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jpeg" ContentType="image/jpeg"/>
  <Default Extension="JPG" ContentType="image/.jpg"/>
  <Default Extension="tiff" ContentType="image/tiff"/>
  <Default Extension="wdp" ContentType="image/vnd.ms-photo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notesMasterIdLst>
    <p:notesMasterId r:id="rId10"/>
  </p:notesMasterIdLst>
  <p:sldIdLst>
    <p:sldId id="335" r:id="rId4"/>
    <p:sldId id="336" r:id="rId5"/>
    <p:sldId id="340" r:id="rId6"/>
    <p:sldId id="343" r:id="rId7"/>
    <p:sldId id="342" r:id="rId8"/>
    <p:sldId id="332" r:id="rId9"/>
    <p:sldId id="315" r:id="rId11"/>
    <p:sldId id="331" r:id="rId12"/>
    <p:sldId id="328" r:id="rId13"/>
    <p:sldId id="329" r:id="rId14"/>
    <p:sldId id="333" r:id="rId15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EE3112"/>
    <a:srgbClr val="CC0099"/>
    <a:srgbClr val="9972FC"/>
    <a:srgbClr val="F486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294" autoAdjust="0"/>
    <p:restoredTop sz="95018" autoAdjust="0"/>
  </p:normalViewPr>
  <p:slideViewPr>
    <p:cSldViewPr>
      <p:cViewPr>
        <p:scale>
          <a:sx n="90" d="100"/>
          <a:sy n="90" d="100"/>
        </p:scale>
        <p:origin x="-1364" y="1232"/>
      </p:cViewPr>
      <p:guideLst>
        <p:guide orient="horz" pos="2880"/>
        <p:guide pos="2160"/>
      </p:guideLst>
    </p:cSldViewPr>
  </p:slideViewPr>
  <p:notesTextViewPr>
    <p:cViewPr>
      <p:scale>
        <a:sx n="33" d="100"/>
        <a:sy n="33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" Type="http://schemas.openxmlformats.org/officeDocument/2006/relationships/theme" Target="theme/theme1.xml"/><Relationship Id="rId18" Type="http://schemas.openxmlformats.org/officeDocument/2006/relationships/tableStyles" Target="tableStyles.xml"/><Relationship Id="rId17" Type="http://schemas.openxmlformats.org/officeDocument/2006/relationships/viewProps" Target="viewProps.xml"/><Relationship Id="rId16" Type="http://schemas.openxmlformats.org/officeDocument/2006/relationships/presProps" Target="presProps.xml"/><Relationship Id="rId15" Type="http://schemas.openxmlformats.org/officeDocument/2006/relationships/slide" Target="slides/slide11.xml"/><Relationship Id="rId14" Type="http://schemas.openxmlformats.org/officeDocument/2006/relationships/slide" Target="slides/slide10.xml"/><Relationship Id="rId13" Type="http://schemas.openxmlformats.org/officeDocument/2006/relationships/slide" Target="slides/slide9.xml"/><Relationship Id="rId12" Type="http://schemas.openxmlformats.org/officeDocument/2006/relationships/slide" Target="slides/slide8.xml"/><Relationship Id="rId11" Type="http://schemas.openxmlformats.org/officeDocument/2006/relationships/slide" Target="slides/slide7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1.emf"/></Relationships>
</file>

<file path=ppt/drawings/_rels/vmlDrawing4.vml.rels><?xml version="1.0" encoding="UTF-8" standalone="yes"?>
<Relationships xmlns="http://schemas.openxmlformats.org/package/2006/relationships"><Relationship Id="rId7" Type="http://schemas.openxmlformats.org/officeDocument/2006/relationships/image" Target="../media/image102.emf"/><Relationship Id="rId6" Type="http://schemas.openxmlformats.org/officeDocument/2006/relationships/image" Target="../media/image89.emf"/><Relationship Id="rId5" Type="http://schemas.openxmlformats.org/officeDocument/2006/relationships/image" Target="../media/image88.emf"/><Relationship Id="rId4" Type="http://schemas.openxmlformats.org/officeDocument/2006/relationships/image" Target="../media/image87.emf"/><Relationship Id="rId3" Type="http://schemas.openxmlformats.org/officeDocument/2006/relationships/image" Target="../media/image86.emf"/><Relationship Id="rId2" Type="http://schemas.openxmlformats.org/officeDocument/2006/relationships/image" Target="../media/image85.emf"/><Relationship Id="rId1" Type="http://schemas.openxmlformats.org/officeDocument/2006/relationships/image" Target="../media/image8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F39D31-52C5-4C70-B015-8941BCC0F3E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1D686B-76CC-488B-ACF9-DF793FF61BE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9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0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A54F22-7C70-4B45-AF8D-E1309A0BA63F}" type="slidenum">
              <a:rPr lang="zh-CN" altLang="en-US" smtClean="0">
                <a:solidFill>
                  <a:prstClr val="black"/>
                </a:solidFill>
              </a:rPr>
            </a:fld>
            <a:endParaRPr lang="zh-CN" altLang="en-US">
              <a:solidFill>
                <a:prstClr val="black"/>
              </a:solidFill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1D686B-76CC-488B-ACF9-DF793FF61BE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1D686B-76CC-488B-ACF9-DF793FF61BE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1D686B-76CC-488B-ACF9-DF793FF61BE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9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9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5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2" Type="http://schemas.openxmlformats.org/officeDocument/2006/relationships/theme" Target="../theme/theme2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jpeg"/><Relationship Id="rId8" Type="http://schemas.openxmlformats.org/officeDocument/2006/relationships/image" Target="../media/image7.jpeg"/><Relationship Id="rId7" Type="http://schemas.openxmlformats.org/officeDocument/2006/relationships/image" Target="../media/image6.jpeg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2" Type="http://schemas.openxmlformats.org/officeDocument/2006/relationships/image" Target="../media/image2.jpeg"/><Relationship Id="rId12" Type="http://schemas.openxmlformats.org/officeDocument/2006/relationships/vmlDrawing" Target="../drawings/vmlDrawing1.vml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9.jpeg"/><Relationship Id="rId1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3.x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83.png"/><Relationship Id="rId1" Type="http://schemas.openxmlformats.org/officeDocument/2006/relationships/image" Target="../media/image82.png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oleObject" Target="../embeddings/oleObject8.bin"/><Relationship Id="rId8" Type="http://schemas.openxmlformats.org/officeDocument/2006/relationships/image" Target="../media/image87.emf"/><Relationship Id="rId7" Type="http://schemas.openxmlformats.org/officeDocument/2006/relationships/oleObject" Target="../embeddings/oleObject7.bin"/><Relationship Id="rId6" Type="http://schemas.openxmlformats.org/officeDocument/2006/relationships/image" Target="../media/image8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85.emf"/><Relationship Id="rId3" Type="http://schemas.openxmlformats.org/officeDocument/2006/relationships/oleObject" Target="../embeddings/oleObject5.bin"/><Relationship Id="rId29" Type="http://schemas.openxmlformats.org/officeDocument/2006/relationships/notesSlide" Target="../notesSlides/notesSlide4.xml"/><Relationship Id="rId28" Type="http://schemas.openxmlformats.org/officeDocument/2006/relationships/vmlDrawing" Target="../drawings/vmlDrawing4.vml"/><Relationship Id="rId27" Type="http://schemas.openxmlformats.org/officeDocument/2006/relationships/slideLayout" Target="../slideLayouts/slideLayout7.xml"/><Relationship Id="rId26" Type="http://schemas.openxmlformats.org/officeDocument/2006/relationships/image" Target="../media/image102.emf"/><Relationship Id="rId25" Type="http://schemas.openxmlformats.org/officeDocument/2006/relationships/oleObject" Target="../embeddings/oleObject10.bin"/><Relationship Id="rId24" Type="http://schemas.microsoft.com/office/2007/relationships/hdphoto" Target="../media/image101.wdp"/><Relationship Id="rId23" Type="http://schemas.openxmlformats.org/officeDocument/2006/relationships/image" Target="../media/image100.jpeg"/><Relationship Id="rId22" Type="http://schemas.microsoft.com/office/2007/relationships/hdphoto" Target="../media/image99.wdp"/><Relationship Id="rId21" Type="http://schemas.openxmlformats.org/officeDocument/2006/relationships/image" Target="../media/image98.png"/><Relationship Id="rId20" Type="http://schemas.microsoft.com/office/2007/relationships/hdphoto" Target="../media/image97.wdp"/><Relationship Id="rId2" Type="http://schemas.openxmlformats.org/officeDocument/2006/relationships/image" Target="../media/image84.emf"/><Relationship Id="rId19" Type="http://schemas.openxmlformats.org/officeDocument/2006/relationships/image" Target="../media/image96.jpeg"/><Relationship Id="rId18" Type="http://schemas.microsoft.com/office/2007/relationships/hdphoto" Target="../media/image95.wdp"/><Relationship Id="rId17" Type="http://schemas.openxmlformats.org/officeDocument/2006/relationships/image" Target="../media/image94.png"/><Relationship Id="rId16" Type="http://schemas.microsoft.com/office/2007/relationships/hdphoto" Target="../media/image93.wdp"/><Relationship Id="rId15" Type="http://schemas.openxmlformats.org/officeDocument/2006/relationships/image" Target="../media/image92.png"/><Relationship Id="rId14" Type="http://schemas.microsoft.com/office/2007/relationships/hdphoto" Target="../media/image91.wdp"/><Relationship Id="rId13" Type="http://schemas.openxmlformats.org/officeDocument/2006/relationships/image" Target="../media/image90.png"/><Relationship Id="rId12" Type="http://schemas.openxmlformats.org/officeDocument/2006/relationships/image" Target="../media/image89.emf"/><Relationship Id="rId11" Type="http://schemas.openxmlformats.org/officeDocument/2006/relationships/oleObject" Target="../embeddings/oleObject9.bin"/><Relationship Id="rId10" Type="http://schemas.openxmlformats.org/officeDocument/2006/relationships/image" Target="../media/image88.emf"/><Relationship Id="rId1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jpeg"/><Relationship Id="rId8" Type="http://schemas.microsoft.com/office/2007/relationships/hdphoto" Target="../media/image17.wdp"/><Relationship Id="rId7" Type="http://schemas.openxmlformats.org/officeDocument/2006/relationships/image" Target="../media/image16.jpeg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tiff"/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4" Type="http://schemas.openxmlformats.org/officeDocument/2006/relationships/vmlDrawing" Target="../drawings/vmlDrawing2.vml"/><Relationship Id="rId13" Type="http://schemas.openxmlformats.org/officeDocument/2006/relationships/slideLayout" Target="../slideLayouts/slideLayout7.xml"/><Relationship Id="rId12" Type="http://schemas.openxmlformats.org/officeDocument/2006/relationships/image" Target="../media/image20.emf"/><Relationship Id="rId11" Type="http://schemas.openxmlformats.org/officeDocument/2006/relationships/oleObject" Target="../embeddings/oleObject2.bin"/><Relationship Id="rId10" Type="http://schemas.openxmlformats.org/officeDocument/2006/relationships/image" Target="../media/image19.tiff"/><Relationship Id="rId1" Type="http://schemas.openxmlformats.org/officeDocument/2006/relationships/image" Target="../media/image10.tiff"/></Relationships>
</file>

<file path=ppt/slides/_rels/slide3.xml.rels><?xml version="1.0" encoding="UTF-8" standalone="yes"?>
<Relationships xmlns="http://schemas.openxmlformats.org/package/2006/relationships"><Relationship Id="rId9" Type="http://schemas.microsoft.com/office/2007/relationships/hdphoto" Target="../media/image29.wdp"/><Relationship Id="rId8" Type="http://schemas.openxmlformats.org/officeDocument/2006/relationships/image" Target="../media/image28.png"/><Relationship Id="rId7" Type="http://schemas.openxmlformats.org/officeDocument/2006/relationships/image" Target="../media/image27.png"/><Relationship Id="rId6" Type="http://schemas.microsoft.com/office/2007/relationships/hdphoto" Target="../media/image26.wdp"/><Relationship Id="rId5" Type="http://schemas.openxmlformats.org/officeDocument/2006/relationships/image" Target="../media/image25.png"/><Relationship Id="rId4" Type="http://schemas.microsoft.com/office/2007/relationships/hdphoto" Target="../media/image24.wdp"/><Relationship Id="rId3" Type="http://schemas.openxmlformats.org/officeDocument/2006/relationships/image" Target="../media/image23.jpeg"/><Relationship Id="rId2" Type="http://schemas.microsoft.com/office/2007/relationships/hdphoto" Target="../media/image22.wdp"/><Relationship Id="rId11" Type="http://schemas.openxmlformats.org/officeDocument/2006/relationships/slideLayout" Target="../slideLayouts/slideLayout7.xml"/><Relationship Id="rId10" Type="http://schemas.openxmlformats.org/officeDocument/2006/relationships/image" Target="../media/image30.png"/><Relationship Id="rId1" Type="http://schemas.openxmlformats.org/officeDocument/2006/relationships/image" Target="../media/image21.jpeg"/></Relationships>
</file>

<file path=ppt/slides/_rels/slide4.xml.rels><?xml version="1.0" encoding="UTF-8" standalone="yes"?>
<Relationships xmlns="http://schemas.openxmlformats.org/package/2006/relationships"><Relationship Id="rId4" Type="http://schemas.openxmlformats.org/officeDocument/2006/relationships/vmlDrawing" Target="../drawings/vmlDrawing3.v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31.emf"/><Relationship Id="rId1" Type="http://schemas.openxmlformats.org/officeDocument/2006/relationships/oleObject" Target="../embeddings/oleObject3.bin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40.emf"/><Relationship Id="rId8" Type="http://schemas.microsoft.com/office/2007/relationships/hdphoto" Target="../media/image39.wdp"/><Relationship Id="rId7" Type="http://schemas.openxmlformats.org/officeDocument/2006/relationships/image" Target="../media/image38.png"/><Relationship Id="rId6" Type="http://schemas.microsoft.com/office/2007/relationships/hdphoto" Target="../media/image37.wdp"/><Relationship Id="rId5" Type="http://schemas.openxmlformats.org/officeDocument/2006/relationships/image" Target="../media/image36.jpeg"/><Relationship Id="rId4" Type="http://schemas.microsoft.com/office/2007/relationships/hdphoto" Target="../media/image35.wdp"/><Relationship Id="rId3" Type="http://schemas.openxmlformats.org/officeDocument/2006/relationships/image" Target="../media/image34.jpeg"/><Relationship Id="rId2" Type="http://schemas.microsoft.com/office/2007/relationships/hdphoto" Target="../media/image33.wdp"/><Relationship Id="rId13" Type="http://schemas.openxmlformats.org/officeDocument/2006/relationships/slideLayout" Target="../slideLayouts/slideLayout7.xml"/><Relationship Id="rId12" Type="http://schemas.openxmlformats.org/officeDocument/2006/relationships/image" Target="../media/image43.png"/><Relationship Id="rId11" Type="http://schemas.openxmlformats.org/officeDocument/2006/relationships/image" Target="../media/image42.png"/><Relationship Id="rId10" Type="http://schemas.openxmlformats.org/officeDocument/2006/relationships/image" Target="../media/image41.png"/><Relationship Id="rId1" Type="http://schemas.openxmlformats.org/officeDocument/2006/relationships/image" Target="../media/image32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18.xml"/><Relationship Id="rId2" Type="http://schemas.microsoft.com/office/2007/relationships/hdphoto" Target="../media/image45.wdp"/><Relationship Id="rId1" Type="http://schemas.openxmlformats.org/officeDocument/2006/relationships/image" Target="../media/image4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47.jpeg"/><Relationship Id="rId1" Type="http://schemas.openxmlformats.org/officeDocument/2006/relationships/image" Target="../media/image46.jpeg"/></Relationships>
</file>

<file path=ppt/slides/_rels/slide8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51.png"/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image" Target="../media/image48.png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60.jpeg"/><Relationship Id="rId8" Type="http://schemas.openxmlformats.org/officeDocument/2006/relationships/image" Target="../media/image59.jpeg"/><Relationship Id="rId7" Type="http://schemas.openxmlformats.org/officeDocument/2006/relationships/image" Target="../media/image58.jpeg"/><Relationship Id="rId6" Type="http://schemas.openxmlformats.org/officeDocument/2006/relationships/image" Target="../media/image57.jpeg"/><Relationship Id="rId5" Type="http://schemas.openxmlformats.org/officeDocument/2006/relationships/image" Target="../media/image56.jpeg"/><Relationship Id="rId4" Type="http://schemas.openxmlformats.org/officeDocument/2006/relationships/image" Target="../media/image55.jpeg"/><Relationship Id="rId32" Type="http://schemas.openxmlformats.org/officeDocument/2006/relationships/notesSlide" Target="../notesSlides/notesSlide2.xml"/><Relationship Id="rId31" Type="http://schemas.openxmlformats.org/officeDocument/2006/relationships/slideLayout" Target="../slideLayouts/slideLayout7.xml"/><Relationship Id="rId30" Type="http://schemas.openxmlformats.org/officeDocument/2006/relationships/image" Target="../media/image81.jpeg"/><Relationship Id="rId3" Type="http://schemas.openxmlformats.org/officeDocument/2006/relationships/image" Target="../media/image54.jpeg"/><Relationship Id="rId29" Type="http://schemas.openxmlformats.org/officeDocument/2006/relationships/image" Target="../media/image80.jpeg"/><Relationship Id="rId28" Type="http://schemas.openxmlformats.org/officeDocument/2006/relationships/image" Target="../media/image79.jpeg"/><Relationship Id="rId27" Type="http://schemas.openxmlformats.org/officeDocument/2006/relationships/image" Target="../media/image78.jpeg"/><Relationship Id="rId26" Type="http://schemas.openxmlformats.org/officeDocument/2006/relationships/image" Target="../media/image77.jpeg"/><Relationship Id="rId25" Type="http://schemas.openxmlformats.org/officeDocument/2006/relationships/image" Target="../media/image76.jpeg"/><Relationship Id="rId24" Type="http://schemas.openxmlformats.org/officeDocument/2006/relationships/image" Target="../media/image75.jpeg"/><Relationship Id="rId23" Type="http://schemas.openxmlformats.org/officeDocument/2006/relationships/image" Target="../media/image74.jpeg"/><Relationship Id="rId22" Type="http://schemas.openxmlformats.org/officeDocument/2006/relationships/image" Target="../media/image73.jpeg"/><Relationship Id="rId21" Type="http://schemas.openxmlformats.org/officeDocument/2006/relationships/image" Target="../media/image72.jpeg"/><Relationship Id="rId20" Type="http://schemas.openxmlformats.org/officeDocument/2006/relationships/image" Target="../media/image71.jpeg"/><Relationship Id="rId2" Type="http://schemas.openxmlformats.org/officeDocument/2006/relationships/image" Target="../media/image53.jpeg"/><Relationship Id="rId19" Type="http://schemas.openxmlformats.org/officeDocument/2006/relationships/image" Target="../media/image70.jpeg"/><Relationship Id="rId18" Type="http://schemas.openxmlformats.org/officeDocument/2006/relationships/image" Target="../media/image69.jpeg"/><Relationship Id="rId17" Type="http://schemas.openxmlformats.org/officeDocument/2006/relationships/image" Target="../media/image68.jpeg"/><Relationship Id="rId16" Type="http://schemas.openxmlformats.org/officeDocument/2006/relationships/image" Target="../media/image67.jpeg"/><Relationship Id="rId15" Type="http://schemas.openxmlformats.org/officeDocument/2006/relationships/image" Target="../media/image66.jpeg"/><Relationship Id="rId14" Type="http://schemas.openxmlformats.org/officeDocument/2006/relationships/image" Target="../media/image65.jpeg"/><Relationship Id="rId13" Type="http://schemas.openxmlformats.org/officeDocument/2006/relationships/image" Target="../media/image64.jpeg"/><Relationship Id="rId12" Type="http://schemas.openxmlformats.org/officeDocument/2006/relationships/image" Target="../media/image63.jpeg"/><Relationship Id="rId11" Type="http://schemas.openxmlformats.org/officeDocument/2006/relationships/image" Target="../media/image62.jpeg"/><Relationship Id="rId10" Type="http://schemas.openxmlformats.org/officeDocument/2006/relationships/image" Target="../media/image61.jpeg"/><Relationship Id="rId1" Type="http://schemas.openxmlformats.org/officeDocument/2006/relationships/image" Target="../media/image5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F:\桌面文件\图片\201\rj\wt-3.jpg"/>
          <p:cNvPicPr>
            <a:picLocks noChangeAspect="1" noChangeArrowheads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6706" y="434441"/>
            <a:ext cx="144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15" name="Picture 3" descr="F:\桌面文件\图片\201\rj\spl37-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0894" y="1577441"/>
            <a:ext cx="144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矩形 7"/>
          <p:cNvSpPr/>
          <p:nvPr/>
        </p:nvSpPr>
        <p:spPr>
          <a:xfrm>
            <a:off x="695805" y="4519424"/>
            <a:ext cx="564792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/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development of pollen, stamen and stigma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slightly affected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–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the pollen development and fertility in WT and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ta were shown as means ± SD of three biological replicates.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signiﬁcance was determined by Student’s t-test,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&lt; 0.01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**). (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stamen and stigma development in WT and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/>
        </p:nvGraphicFramePr>
        <p:xfrm>
          <a:off x="1419225" y="2695575"/>
          <a:ext cx="1352550" cy="184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94" name="Prism 8" r:id="rId3" imgW="1876425" imgH="2571750" progId="Prism8.Document">
                  <p:embed/>
                </p:oleObj>
              </mc:Choice>
              <mc:Fallback>
                <p:oleObj name="Prism 8" r:id="rId3" imgW="1876425" imgH="2571750" progId="Prism8.Document">
                  <p:embed/>
                  <p:pic>
                    <p:nvPicPr>
                      <p:cNvPr id="0" name="图片 2469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19225" y="2695575"/>
                        <a:ext cx="1352550" cy="18478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304964" y="1312400"/>
            <a:ext cx="33534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304964" y="2481863"/>
            <a:ext cx="41870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316" name="Picture 4" descr="F:\桌面文件\图片\20240914柱头\WT-4.jpg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95" r="23233"/>
          <a:stretch>
            <a:fillRect/>
          </a:stretch>
        </p:blipFill>
        <p:spPr bwMode="auto">
          <a:xfrm>
            <a:off x="3069504" y="434441"/>
            <a:ext cx="1079489" cy="11992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F:\桌面文件\图片\20240914柱头\WT-11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581"/>
          <a:stretch>
            <a:fillRect/>
          </a:stretch>
        </p:blipFill>
        <p:spPr bwMode="auto">
          <a:xfrm>
            <a:off x="4176362" y="434441"/>
            <a:ext cx="1233141" cy="11992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24" name="Picture 12" descr="F:\桌面文件\图片\20240914柱头\lmm9-14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98" t="10436" r="26968"/>
          <a:stretch>
            <a:fillRect/>
          </a:stretch>
        </p:blipFill>
        <p:spPr bwMode="auto">
          <a:xfrm>
            <a:off x="3078810" y="1710120"/>
            <a:ext cx="1074130" cy="11985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326" name="Picture 14" descr="F:\桌面文件\图片\20240914柱头\spl37-4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8" r="27868" b="9721"/>
          <a:stretch>
            <a:fillRect/>
          </a:stretch>
        </p:blipFill>
        <p:spPr bwMode="auto">
          <a:xfrm>
            <a:off x="4185668" y="1710120"/>
            <a:ext cx="1233141" cy="11985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3069504" y="1412521"/>
            <a:ext cx="33534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131261" y="1416796"/>
            <a:ext cx="33534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037760" y="2976176"/>
            <a:ext cx="2378370" cy="1199297"/>
            <a:chOff x="3037760" y="2909501"/>
            <a:chExt cx="2378370" cy="1199297"/>
          </a:xfrm>
        </p:grpSpPr>
        <p:pic>
          <p:nvPicPr>
            <p:cNvPr id="4" name="Picture 3" descr="F:\桌面文件\图片\20240914柱头\lmm9-7-1.jpg"/>
            <p:cNvPicPr>
              <a:picLocks noChangeAspect="1" noChangeArrowheads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581"/>
            <a:stretch>
              <a:fillRect/>
            </a:stretch>
          </p:blipFill>
          <p:spPr bwMode="auto">
            <a:xfrm>
              <a:off x="4182989" y="2909501"/>
              <a:ext cx="1233141" cy="119929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F:\桌面文件\图片\20240914柱头\lmm9-9.jpg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3059"/>
            <a:stretch>
              <a:fillRect/>
            </a:stretch>
          </p:blipFill>
          <p:spPr bwMode="auto">
            <a:xfrm>
              <a:off x="3076130" y="2909501"/>
              <a:ext cx="1066236" cy="119929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25"/>
            <p:cNvSpPr txBox="1"/>
            <p:nvPr/>
          </p:nvSpPr>
          <p:spPr>
            <a:xfrm>
              <a:off x="3037760" y="3889262"/>
              <a:ext cx="43473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mm9</a:t>
              </a:r>
              <a:endParaRPr lang="zh-CN" altLang="en-US" sz="75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150260" y="3889262"/>
              <a:ext cx="43473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mm9</a:t>
              </a:r>
              <a:endParaRPr lang="zh-CN" altLang="en-US" sz="75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4118647" y="2691993"/>
            <a:ext cx="43473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052381" y="2692974"/>
            <a:ext cx="43473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018990" y="255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790894" y="255207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18990" y="2646834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790894" y="4273203"/>
            <a:ext cx="43473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b="1" i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b="1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/>
          <p:cNvGrpSpPr/>
          <p:nvPr/>
        </p:nvGrpSpPr>
        <p:grpSpPr>
          <a:xfrm>
            <a:off x="1332773" y="2811071"/>
            <a:ext cx="981612" cy="1699456"/>
            <a:chOff x="3895626" y="3258616"/>
            <a:chExt cx="981612" cy="1699456"/>
          </a:xfrm>
        </p:grpSpPr>
        <p:sp>
          <p:nvSpPr>
            <p:cNvPr id="31" name="TextBox 30"/>
            <p:cNvSpPr txBox="1"/>
            <p:nvPr/>
          </p:nvSpPr>
          <p:spPr>
            <a:xfrm>
              <a:off x="4054212" y="3258616"/>
              <a:ext cx="1586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107112" y="3567458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107112" y="3876300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107112" y="4185142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160010" y="4493985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3534469" y="3793759"/>
              <a:ext cx="93006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llen fertility (%)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8059508">
              <a:off x="4329090" y="4609118"/>
              <a:ext cx="3353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8059508">
              <a:off x="4564012" y="4644845"/>
              <a:ext cx="4187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73364" y="3625166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/>
          <p:cNvSpPr/>
          <p:nvPr/>
        </p:nvSpPr>
        <p:spPr>
          <a:xfrm>
            <a:off x="569764" y="4425361"/>
            <a:ext cx="567428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0.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ially expressed genes wer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in RNA-Seq with WT and MN (mutant without lesion), MU (mutan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sion)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enn diagram of the intersection of differentially expressed gene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WT vs MN, WT vs MU, MN vs MU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enrichment analysis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mon differentially expresse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(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) with WT vs MU and MN vs MU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2" descr="C:\Users\rj\Documents\Tencent Files\653271706\FileRecv\jVenn_chart.png"/>
          <p:cNvPicPr>
            <a:picLocks noChangeAspect="1" noChangeArrowheads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9368" y="992390"/>
            <a:ext cx="2091978" cy="309821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图片 8" descr="C:\Users\Lenovo\Desktop\2-7\转录组\1107个差异基因\kegg\KEGG_1.png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50"/>
          <a:stretch>
            <a:fillRect/>
          </a:stretch>
        </p:blipFill>
        <p:spPr>
          <a:xfrm>
            <a:off x="3190634" y="992390"/>
            <a:ext cx="2974670" cy="2890228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/>
          <p:cNvSpPr txBox="1"/>
          <p:nvPr/>
        </p:nvSpPr>
        <p:spPr>
          <a:xfrm>
            <a:off x="631504" y="80137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016739" y="80137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942429" y="893744"/>
            <a:ext cx="1755574" cy="2650877"/>
            <a:chOff x="620688" y="841624"/>
            <a:chExt cx="1968031" cy="2971682"/>
          </a:xfrm>
        </p:grpSpPr>
        <p:grpSp>
          <p:nvGrpSpPr>
            <p:cNvPr id="15" name="组合 14"/>
            <p:cNvGrpSpPr/>
            <p:nvPr/>
          </p:nvGrpSpPr>
          <p:grpSpPr>
            <a:xfrm>
              <a:off x="692696" y="968401"/>
              <a:ext cx="1752007" cy="2075547"/>
              <a:chOff x="692696" y="968401"/>
              <a:chExt cx="1752007" cy="2075547"/>
            </a:xfrm>
          </p:grpSpPr>
          <p:sp>
            <p:nvSpPr>
              <p:cNvPr id="26" name="矩形 25"/>
              <p:cNvSpPr/>
              <p:nvPr/>
            </p:nvSpPr>
            <p:spPr>
              <a:xfrm>
                <a:off x="2228679" y="968401"/>
                <a:ext cx="216024" cy="1138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26"/>
              <p:cNvSpPr/>
              <p:nvPr/>
            </p:nvSpPr>
            <p:spPr>
              <a:xfrm>
                <a:off x="1484784" y="2930105"/>
                <a:ext cx="216024" cy="1138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矩形 27"/>
              <p:cNvSpPr/>
              <p:nvPr/>
            </p:nvSpPr>
            <p:spPr>
              <a:xfrm>
                <a:off x="692696" y="968402"/>
                <a:ext cx="216024" cy="1138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" name="矩形 16"/>
            <p:cNvSpPr/>
            <p:nvPr/>
          </p:nvSpPr>
          <p:spPr>
            <a:xfrm>
              <a:off x="620688" y="841624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  <a:r>
                <a:rPr lang="en-US" altLang="zh-CN" sz="75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zh-CN" altLang="en-US" sz="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1868639" y="841624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  <a:r>
                <a:rPr lang="en-US" altLang="zh-CN" sz="75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N</a:t>
              </a:r>
              <a:endParaRPr lang="zh-CN" altLang="en-US" sz="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1251806" y="2860249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N </a:t>
              </a:r>
              <a:r>
                <a:rPr lang="en-US" altLang="zh-CN" sz="75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75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zh-CN" altLang="en-US" sz="7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927708" y="3658121"/>
              <a:ext cx="216024" cy="1138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/>
            <p:cNvSpPr/>
            <p:nvPr/>
          </p:nvSpPr>
          <p:spPr>
            <a:xfrm>
              <a:off x="1497484" y="3667417"/>
              <a:ext cx="216024" cy="1138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/>
            <p:cNvSpPr/>
            <p:nvPr/>
          </p:nvSpPr>
          <p:spPr>
            <a:xfrm>
              <a:off x="2085060" y="3658772"/>
              <a:ext cx="216024" cy="1138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/>
            <p:cNvSpPr/>
            <p:nvPr/>
          </p:nvSpPr>
          <p:spPr>
            <a:xfrm>
              <a:off x="669330" y="3559753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  <a:r>
                <a:rPr lang="en-US" altLang="zh-CN" sz="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843239" y="3559461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N </a:t>
              </a:r>
              <a:r>
                <a:rPr lang="en-US" altLang="zh-CN" sz="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U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/>
            <p:cNvSpPr/>
            <p:nvPr/>
          </p:nvSpPr>
          <p:spPr>
            <a:xfrm>
              <a:off x="1248631" y="3559753"/>
              <a:ext cx="720080" cy="2535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 </a:t>
              </a:r>
              <a:r>
                <a:rPr lang="en-US" altLang="zh-CN" sz="500" dirty="0" err="1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s</a:t>
              </a:r>
              <a:r>
                <a:rPr lang="en-US" altLang="zh-CN" sz="5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MN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812604" y="6228184"/>
            <a:ext cx="563290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/>
            <a:r>
              <a:rPr lang="en-US" altLang="zh-CN" sz="1200" b="1" dirty="0" smtClean="0">
                <a:latin typeface="Times New Roman" panose="02020603050405020304"/>
                <a:cs typeface="宋体" panose="02010600030101010101" pitchFamily="2" charset="-122"/>
              </a:rPr>
              <a:t>Figure S11.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The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expression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of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tryptophan degradation genes was affected by </a:t>
            </a:r>
            <a:r>
              <a:rPr lang="en-US" altLang="zh-CN" sz="1200" i="1" dirty="0" smtClean="0">
                <a:latin typeface="Times New Roman" panose="02020603050405020304"/>
                <a:cs typeface="宋体" panose="02010600030101010101" pitchFamily="2" charset="-122"/>
              </a:rPr>
              <a:t>OsPAT1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 expression.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(</a:t>
            </a:r>
            <a:r>
              <a:rPr lang="en-US" altLang="zh-CN" sz="1200" b="1" dirty="0" smtClean="0">
                <a:latin typeface="Times New Roman" panose="02020603050405020304"/>
                <a:cs typeface="宋体" panose="02010600030101010101" pitchFamily="2" charset="-122"/>
              </a:rPr>
              <a:t>a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)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Biosynthetic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pathway from tryptophan to melatonin in plants. TDC, tryptophan decarboxylase; T5H, tryptamine 5-hydroxylase; COMT, flavone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3‘-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O-methyltransferase; SNAT, serotonin N-acetyltransferase; ASDAC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, N-acetylserotonin deacetylase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; ASMT, N‐acetylserotonin methyltransferase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.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Schematic diagram was drawn by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KingDraw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.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 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(</a:t>
            </a:r>
            <a:r>
              <a:rPr lang="en-US" altLang="zh-CN" sz="1200" b="1" dirty="0" smtClean="0">
                <a:latin typeface="Times New Roman" panose="02020603050405020304"/>
                <a:cs typeface="宋体" panose="02010600030101010101" pitchFamily="2" charset="-122"/>
              </a:rPr>
              <a:t>b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)</a:t>
            </a:r>
            <a:r>
              <a:rPr lang="en-US" altLang="zh-CN" sz="1200" dirty="0" smtClean="0">
                <a:latin typeface="Times New Roman" panose="02020603050405020304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Relative expression analysis of melatonin synthesis genes in WT, </a:t>
            </a:r>
            <a:r>
              <a:rPr lang="en-US" altLang="zh-CN" sz="1200" i="1" dirty="0">
                <a:latin typeface="Times New Roman" panose="02020603050405020304"/>
                <a:cs typeface="宋体" panose="02010600030101010101" pitchFamily="2" charset="-122"/>
              </a:rPr>
              <a:t>lmm9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 and transgenic plants</a:t>
            </a:r>
            <a:r>
              <a:rPr lang="en-US" altLang="zh-CN" sz="1200" i="1" dirty="0">
                <a:latin typeface="Times New Roman" panose="02020603050405020304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at tillering stage. Data were shown as means ± SD of three replicates. The signiﬁcance was determined by Student’s t-test, </a:t>
            </a:r>
            <a:r>
              <a:rPr lang="en-US" altLang="zh-CN" sz="1200" i="1" dirty="0">
                <a:latin typeface="Times New Roman" panose="02020603050405020304"/>
                <a:cs typeface="宋体" panose="02010600030101010101" pitchFamily="2" charset="-122"/>
              </a:rPr>
              <a:t>P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 &lt; 0.05(*), </a:t>
            </a:r>
            <a:r>
              <a:rPr lang="en-US" altLang="zh-CN" sz="1200" i="1" dirty="0">
                <a:latin typeface="Times New Roman" panose="02020603050405020304"/>
                <a:cs typeface="宋体" panose="02010600030101010101" pitchFamily="2" charset="-122"/>
              </a:rPr>
              <a:t>P</a:t>
            </a:r>
            <a:r>
              <a:rPr lang="en-US" altLang="zh-CN" sz="1200" dirty="0">
                <a:latin typeface="Times New Roman" panose="02020603050405020304"/>
                <a:cs typeface="宋体" panose="02010600030101010101" pitchFamily="2" charset="-122"/>
              </a:rPr>
              <a:t> &lt; 0.01(**).</a:t>
            </a:r>
            <a:endParaRPr lang="zh-CN" altLang="zh-CN" sz="1200" dirty="0">
              <a:latin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126315" y="392392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124744" y="53162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2" name="对象 61"/>
          <p:cNvGraphicFramePr>
            <a:graphicFrameLocks noChangeAspect="1"/>
          </p:cNvGraphicFramePr>
          <p:nvPr/>
        </p:nvGraphicFramePr>
        <p:xfrm>
          <a:off x="3425641" y="2498463"/>
          <a:ext cx="968149" cy="3574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36" name="KingDrawXObject" r:id="rId1" imgW="1858645" imgH="688975" progId="KingDrawXObject">
                  <p:embed/>
                </p:oleObj>
              </mc:Choice>
              <mc:Fallback>
                <p:oleObj name="KingDrawXObject" r:id="rId1" imgW="1858645" imgH="688975" progId="KingDrawXObject">
                  <p:embed/>
                  <p:pic>
                    <p:nvPicPr>
                      <p:cNvPr id="0" name="图片 2443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5641" y="2498463"/>
                        <a:ext cx="968149" cy="35747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3" name="TextBox 62"/>
          <p:cNvSpPr txBox="1"/>
          <p:nvPr/>
        </p:nvSpPr>
        <p:spPr>
          <a:xfrm>
            <a:off x="3528268" y="2865126"/>
            <a:ext cx="961802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5-methoxytryptamine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接箭头连接符 65"/>
          <p:cNvCxnSpPr/>
          <p:nvPr/>
        </p:nvCxnSpPr>
        <p:spPr>
          <a:xfrm rot="5400000">
            <a:off x="2049115" y="1469829"/>
            <a:ext cx="37529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1960136" y="1108297"/>
            <a:ext cx="580287" cy="101745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tryptophan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4" name="对象 83"/>
          <p:cNvGraphicFramePr>
            <a:graphicFrameLocks noChangeAspect="1"/>
          </p:cNvGraphicFramePr>
          <p:nvPr/>
        </p:nvGraphicFramePr>
        <p:xfrm>
          <a:off x="1859634" y="742100"/>
          <a:ext cx="973113" cy="37236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37" name="KingDrawXObject" r:id="rId3" imgW="1875790" imgH="718820" progId="KingDrawXObject">
                  <p:embed/>
                </p:oleObj>
              </mc:Choice>
              <mc:Fallback>
                <p:oleObj name="KingDrawXObject" r:id="rId3" imgW="1875790" imgH="718820" progId="KingDrawXObject">
                  <p:embed/>
                  <p:pic>
                    <p:nvPicPr>
                      <p:cNvPr id="0" name="图片 2443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59634" y="742100"/>
                        <a:ext cx="973113" cy="37236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6" name="对象 85"/>
          <p:cNvGraphicFramePr>
            <a:graphicFrameLocks noChangeAspect="1"/>
          </p:cNvGraphicFramePr>
          <p:nvPr/>
        </p:nvGraphicFramePr>
        <p:xfrm>
          <a:off x="1917080" y="1649656"/>
          <a:ext cx="724869" cy="347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38" name="KingDrawXObject" r:id="rId5" imgW="1399540" imgH="668020" progId="KingDrawXObject">
                  <p:embed/>
                </p:oleObj>
              </mc:Choice>
              <mc:Fallback>
                <p:oleObj name="KingDrawXObject" r:id="rId5" imgW="1399540" imgH="668020" progId="KingDrawXObject">
                  <p:embed/>
                  <p:pic>
                    <p:nvPicPr>
                      <p:cNvPr id="0" name="图片 2443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17080" y="1649656"/>
                        <a:ext cx="724869" cy="347541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7" name="TextBox 86"/>
          <p:cNvSpPr txBox="1"/>
          <p:nvPr/>
        </p:nvSpPr>
        <p:spPr>
          <a:xfrm>
            <a:off x="2001259" y="1979175"/>
            <a:ext cx="484751" cy="11541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ryptamine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直接箭头连接符 87"/>
          <p:cNvCxnSpPr/>
          <p:nvPr/>
        </p:nvCxnSpPr>
        <p:spPr>
          <a:xfrm rot="5400000">
            <a:off x="2049115" y="2331019"/>
            <a:ext cx="37529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箭头连接符 88"/>
          <p:cNvCxnSpPr/>
          <p:nvPr/>
        </p:nvCxnSpPr>
        <p:spPr>
          <a:xfrm>
            <a:off x="2900512" y="2677202"/>
            <a:ext cx="37529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1" name="对象 90"/>
          <p:cNvGraphicFramePr>
            <a:graphicFrameLocks noChangeAspect="1"/>
          </p:cNvGraphicFramePr>
          <p:nvPr/>
        </p:nvGraphicFramePr>
        <p:xfrm>
          <a:off x="1753600" y="2503432"/>
          <a:ext cx="918499" cy="347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39" name="KingDrawXObject" r:id="rId7" imgW="1765300" imgH="668020" progId="KingDrawXObject">
                  <p:embed/>
                </p:oleObj>
              </mc:Choice>
              <mc:Fallback>
                <p:oleObj name="KingDrawXObject" r:id="rId7" imgW="1765300" imgH="668020" progId="KingDrawXObject">
                  <p:embed/>
                  <p:pic>
                    <p:nvPicPr>
                      <p:cNvPr id="0" name="图片 2443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53600" y="2503432"/>
                        <a:ext cx="918499" cy="34754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TextBox 91"/>
          <p:cNvSpPr txBox="1"/>
          <p:nvPr/>
        </p:nvSpPr>
        <p:spPr>
          <a:xfrm>
            <a:off x="2053911" y="2866039"/>
            <a:ext cx="408766" cy="11541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Serotoni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直接箭头连接符 92"/>
          <p:cNvCxnSpPr/>
          <p:nvPr/>
        </p:nvCxnSpPr>
        <p:spPr>
          <a:xfrm>
            <a:off x="2208132" y="3028305"/>
            <a:ext cx="0" cy="33780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箭头连接符 105"/>
          <p:cNvCxnSpPr/>
          <p:nvPr/>
        </p:nvCxnSpPr>
        <p:spPr>
          <a:xfrm flipV="1">
            <a:off x="2281860" y="3028305"/>
            <a:ext cx="0" cy="337804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9" name="对象 108"/>
          <p:cNvGraphicFramePr>
            <a:graphicFrameLocks noChangeAspect="1"/>
          </p:cNvGraphicFramePr>
          <p:nvPr/>
        </p:nvGraphicFramePr>
        <p:xfrm>
          <a:off x="1718494" y="3368808"/>
          <a:ext cx="1122060" cy="337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40" name="KingDrawXObject" r:id="rId9" imgW="2156460" imgH="650875" progId="KingDrawXObject">
                  <p:embed/>
                </p:oleObj>
              </mc:Choice>
              <mc:Fallback>
                <p:oleObj name="KingDrawXObject" r:id="rId9" imgW="2156460" imgH="650875" progId="KingDrawXObject">
                  <p:embed/>
                  <p:pic>
                    <p:nvPicPr>
                      <p:cNvPr id="0" name="图片 2443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18494" y="3368808"/>
                        <a:ext cx="1122060" cy="33761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0" name="TextBox 109"/>
          <p:cNvSpPr txBox="1"/>
          <p:nvPr/>
        </p:nvSpPr>
        <p:spPr>
          <a:xfrm>
            <a:off x="1862353" y="3719835"/>
            <a:ext cx="775853" cy="11541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-acetylserotoni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直接箭头连接符 110"/>
          <p:cNvCxnSpPr/>
          <p:nvPr/>
        </p:nvCxnSpPr>
        <p:spPr>
          <a:xfrm>
            <a:off x="3993401" y="3028305"/>
            <a:ext cx="0" cy="33780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箭头连接符 111"/>
          <p:cNvCxnSpPr/>
          <p:nvPr/>
        </p:nvCxnSpPr>
        <p:spPr>
          <a:xfrm>
            <a:off x="2900512" y="3521995"/>
            <a:ext cx="37529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4" name="对象 113"/>
          <p:cNvGraphicFramePr>
            <a:graphicFrameLocks noChangeAspect="1"/>
          </p:cNvGraphicFramePr>
          <p:nvPr/>
        </p:nvGraphicFramePr>
        <p:xfrm>
          <a:off x="3403688" y="3292012"/>
          <a:ext cx="1315688" cy="4071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441" name="KingDrawXObject" r:id="rId11" imgW="2530475" imgH="778510" progId="KingDrawXObject">
                  <p:embed/>
                </p:oleObj>
              </mc:Choice>
              <mc:Fallback>
                <p:oleObj name="KingDrawXObject" r:id="rId11" imgW="2530475" imgH="778510" progId="KingDrawXObject">
                  <p:embed/>
                  <p:pic>
                    <p:nvPicPr>
                      <p:cNvPr id="0" name="图片 2444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03688" y="3292012"/>
                        <a:ext cx="1315688" cy="407119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6" name="TextBox 115"/>
          <p:cNvSpPr txBox="1"/>
          <p:nvPr/>
        </p:nvSpPr>
        <p:spPr>
          <a:xfrm>
            <a:off x="3802382" y="3719843"/>
            <a:ext cx="413575" cy="11541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elatoni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280044" y="1370408"/>
            <a:ext cx="19717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DC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285955" y="2236452"/>
            <a:ext cx="18114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5H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886221" y="3118837"/>
            <a:ext cx="26129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AT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341493" y="3118837"/>
            <a:ext cx="339837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DAC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939882" y="2490333"/>
            <a:ext cx="28373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MT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4024730" y="3118837"/>
            <a:ext cx="39433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AT1/2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848975" y="3294906"/>
            <a:ext cx="4783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SMT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1809236" y="1221897"/>
            <a:ext cx="434734" cy="4385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TDC1</a:t>
            </a:r>
            <a:endParaRPr lang="en-US" altLang="zh-CN" sz="750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TDC2</a:t>
            </a:r>
            <a:endParaRPr lang="en-US" altLang="zh-CN" sz="750" i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TDC3</a:t>
            </a:r>
            <a:endParaRPr lang="zh-CN" altLang="en-US" sz="7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739347" y="2689742"/>
            <a:ext cx="70243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OsCOMT15</a:t>
            </a:r>
            <a:endParaRPr lang="zh-CN" altLang="en-US" sz="7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610694" y="2164843"/>
            <a:ext cx="61587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 algn="ctr"/>
            <a:r>
              <a:rPr lang="en-US" altLang="zh-CN" sz="75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5H </a:t>
            </a:r>
            <a:endParaRPr lang="en-US" altLang="zh-CN" sz="750" i="1" dirty="0" smtClean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algn="ctr"/>
            <a:r>
              <a:rPr lang="en-US" altLang="zh-CN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zh-CN" sz="750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L1/SL</a:t>
            </a:r>
            <a:r>
              <a:rPr lang="en-US" altLang="zh-CN" sz="7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750" i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8" name="Picture 9" descr="C:\Users\rj\Desktop\微信图片_20241115205115.pn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61" t="4614" r="60999" b="54158"/>
          <a:stretch>
            <a:fillRect/>
          </a:stretch>
        </p:blipFill>
        <p:spPr bwMode="auto">
          <a:xfrm>
            <a:off x="1583473" y="1290938"/>
            <a:ext cx="288000" cy="3096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9" name="Picture 9" descr="C:\Users\rj\Desktop\微信图片_20241115205115.pn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87" t="45926" r="60973" b="40327"/>
          <a:stretch>
            <a:fillRect/>
          </a:stretch>
        </p:blipFill>
        <p:spPr bwMode="auto">
          <a:xfrm>
            <a:off x="1340768" y="2267744"/>
            <a:ext cx="288000" cy="103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0" name="Picture 9" descr="C:\Users\rj\Desktop\微信图片_20241115205115.pn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031" t="59707" r="60829" b="26546"/>
          <a:stretch>
            <a:fillRect/>
          </a:stretch>
        </p:blipFill>
        <p:spPr bwMode="auto">
          <a:xfrm>
            <a:off x="2944160" y="2874219"/>
            <a:ext cx="288000" cy="103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6" name="TextBox 55"/>
          <p:cNvSpPr txBox="1"/>
          <p:nvPr/>
        </p:nvSpPr>
        <p:spPr>
          <a:xfrm rot="18388248">
            <a:off x="3592917" y="1152644"/>
            <a:ext cx="64472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N vs 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8388248">
            <a:off x="3910591" y="1143816"/>
            <a:ext cx="643125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U vs M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388248">
            <a:off x="3747101" y="1156576"/>
            <a:ext cx="64472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U vs 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0" name="Picture 3" descr="C:\Users\rj\Desktop\微信图片_20241115205053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761" r="23971" b="50000"/>
          <a:stretch>
            <a:fillRect/>
          </a:stretch>
        </p:blipFill>
        <p:spPr bwMode="auto">
          <a:xfrm>
            <a:off x="3298340" y="933780"/>
            <a:ext cx="311299" cy="7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4" name="TextBox 63"/>
          <p:cNvSpPr txBox="1"/>
          <p:nvPr/>
        </p:nvSpPr>
        <p:spPr>
          <a:xfrm>
            <a:off x="3688890" y="812670"/>
            <a:ext cx="699230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223185" y="812670"/>
            <a:ext cx="51007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Z-score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圆角矩形 66"/>
          <p:cNvSpPr/>
          <p:nvPr/>
        </p:nvSpPr>
        <p:spPr>
          <a:xfrm>
            <a:off x="3200259" y="780568"/>
            <a:ext cx="1956933" cy="970801"/>
          </a:xfrm>
          <a:prstGeom prst="round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7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395027" y="883010"/>
            <a:ext cx="699230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ce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4554525" y="1276231"/>
            <a:ext cx="43313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q&lt;0.1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Picture 3" descr="C:\Users\rj\Desktop\微信图片_20241115205053.jpg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664" t="65813" r="70126" b="27626"/>
          <a:stretch>
            <a:fillRect/>
          </a:stretch>
        </p:blipFill>
        <p:spPr bwMode="auto">
          <a:xfrm>
            <a:off x="3739024" y="1484134"/>
            <a:ext cx="459357" cy="1583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3" name="Picture 3" descr="C:\Users\rj\Desktop\微信图片_20241115205053.jpg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saturation sat="4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867" t="1459" r="82468" b="92511"/>
          <a:stretch>
            <a:fillRect/>
          </a:stretch>
        </p:blipFill>
        <p:spPr bwMode="auto">
          <a:xfrm>
            <a:off x="4684571" y="1119313"/>
            <a:ext cx="144000" cy="1466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95" name="组合 94"/>
          <p:cNvGrpSpPr/>
          <p:nvPr/>
        </p:nvGrpSpPr>
        <p:grpSpPr>
          <a:xfrm>
            <a:off x="1124744" y="3949912"/>
            <a:ext cx="4233614" cy="2206625"/>
            <a:chOff x="1376038" y="4957688"/>
            <a:chExt cx="4233614" cy="2206625"/>
          </a:xfrm>
        </p:grpSpPr>
        <p:graphicFrame>
          <p:nvGraphicFramePr>
            <p:cNvPr id="96" name="对象 95"/>
            <p:cNvGraphicFramePr>
              <a:graphicFrameLocks noChangeAspect="1"/>
            </p:cNvGraphicFramePr>
            <p:nvPr/>
          </p:nvGraphicFramePr>
          <p:xfrm>
            <a:off x="1594865" y="4957688"/>
            <a:ext cx="4014787" cy="2206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4442" name="Prism 8" r:id="rId25" imgW="6696075" imgH="3686175" progId="Prism8.Document">
                    <p:embed/>
                  </p:oleObj>
                </mc:Choice>
                <mc:Fallback>
                  <p:oleObj name="Prism 8" r:id="rId25" imgW="6696075" imgH="3686175" progId="Prism8.Document">
                    <p:embed/>
                    <p:pic>
                      <p:nvPicPr>
                        <p:cNvPr id="0" name="图片 24441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26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594865" y="4957688"/>
                          <a:ext cx="4014787" cy="2206625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7" name="TextBox 96"/>
            <p:cNvSpPr txBox="1"/>
            <p:nvPr/>
          </p:nvSpPr>
          <p:spPr>
            <a:xfrm rot="10800000">
              <a:off x="1376038" y="5470983"/>
              <a:ext cx="300082" cy="1148712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expression level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065072" y="5046031"/>
              <a:ext cx="3353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065072" y="5202947"/>
              <a:ext cx="4187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669844" y="5035116"/>
              <a:ext cx="657552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-Ri-1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675602" y="5197307"/>
              <a:ext cx="71045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-Ri-34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605602" y="5035116"/>
              <a:ext cx="769763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-Com-7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605602" y="5183246"/>
              <a:ext cx="822661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-Com-27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2103765" y="6833020"/>
              <a:ext cx="25006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DC1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775360" y="6833020"/>
              <a:ext cx="25006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DC2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3479664" y="6833020"/>
              <a:ext cx="25006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DC3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963029" y="6832848"/>
              <a:ext cx="666849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5H  </a:t>
              </a:r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LL1/SL</a:t>
              </a:r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760414" y="6833020"/>
              <a:ext cx="512961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i="1" dirty="0">
                  <a:latin typeface="Arial" panose="020B0604020202020204" pitchFamily="34" charset="0"/>
                  <a:cs typeface="Arial" panose="020B0604020202020204" pitchFamily="34" charset="0"/>
                </a:rPr>
                <a:t>OsCOMT15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724608" y="6344672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650138" y="6528217"/>
              <a:ext cx="13305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1711219" y="6709492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658321" y="6149124"/>
              <a:ext cx="13305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.5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682153" y="5660523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1683739" y="5429691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684383" y="5889573"/>
              <a:ext cx="1057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626871" y="5204985"/>
              <a:ext cx="15869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4898996" y="6032229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5003318" y="5947281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5105723" y="6364905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800640" y="6173644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4521004" y="6651784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431240" y="6446571"/>
              <a:ext cx="3687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310362" y="5667823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208774" y="5611528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092278" y="5829936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3400741" y="5718231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504901" y="5545107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605933" y="5572011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824064" y="6561987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3121716" y="6594076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3019064" y="6616967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2914045" y="6632540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2805785" y="6618535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2697941" y="6619695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2432293" y="6349435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2328855" y="6286964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2220750" y="5629719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2115342" y="5408866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2013674" y="5552407"/>
              <a:ext cx="73738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矩形 67"/>
          <p:cNvSpPr/>
          <p:nvPr/>
        </p:nvSpPr>
        <p:spPr>
          <a:xfrm>
            <a:off x="512610" y="4932040"/>
            <a:ext cx="5715385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evelopmen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hloroplasts and mitochondria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affected in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altLang="zh-CN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–h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mission electron microscopy (TEM) images of chloroplasts and mitochondria in WT and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tillering stage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y, thylakoid; Og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mionphilic granules;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g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rch granule;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,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loroplast;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, cristae; OM, outer membran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M, inner membranes. </a:t>
            </a:r>
            <a:r>
              <a:rPr lang="it-IT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: 5µm in (a, e), 1µm in (b, c, f, g), 0.5µm </a:t>
            </a:r>
            <a:r>
              <a:rPr lang="it-IT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it-IT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, h</a:t>
            </a:r>
            <a:r>
              <a:rPr lang="it-IT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otosynthetic pigment contents of WT and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t tillering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ge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hl a, chlorophyll a; Chl b, chlorophyll 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, carotene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shown as mean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± SD of three biological replicates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he signiﬁcance was determine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y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tudent’s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-tes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,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(*)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**)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/>
          <p:cNvGrpSpPr>
            <a:grpSpLocks noChangeAspect="1"/>
          </p:cNvGrpSpPr>
          <p:nvPr/>
        </p:nvGrpSpPr>
        <p:grpSpPr>
          <a:xfrm>
            <a:off x="3554353" y="554861"/>
            <a:ext cx="2427201" cy="1901998"/>
            <a:chOff x="1130872" y="4567235"/>
            <a:chExt cx="2427201" cy="1901998"/>
          </a:xfrm>
        </p:grpSpPr>
        <p:pic>
          <p:nvPicPr>
            <p:cNvPr id="3" name="Picture 2" descr="F:\桌面文件\图片\透射电镜\spl3\Img4743.tif"/>
            <p:cNvPicPr>
              <a:picLocks noChangeAspect="1" noChangeArrowheads="1"/>
            </p:cNvPicPr>
            <p:nvPr/>
          </p:nvPicPr>
          <p:blipFill rotWithShape="1"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30872" y="5534306"/>
              <a:ext cx="1293620" cy="93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548" t="39686" r="15202" b="8894"/>
            <a:stretch>
              <a:fillRect/>
            </a:stretch>
          </p:blipFill>
          <p:spPr>
            <a:xfrm>
              <a:off x="2449855" y="5536833"/>
              <a:ext cx="1100327" cy="932400"/>
            </a:xfrm>
            <a:prstGeom prst="rect">
              <a:avLst/>
            </a:prstGeom>
          </p:spPr>
        </p:pic>
        <p:pic>
          <p:nvPicPr>
            <p:cNvPr id="5" name="图片 4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58" t="11432" r="16808" b="21916"/>
            <a:stretch>
              <a:fillRect/>
            </a:stretch>
          </p:blipFill>
          <p:spPr>
            <a:xfrm>
              <a:off x="2449854" y="4567235"/>
              <a:ext cx="1108219" cy="932400"/>
            </a:xfrm>
            <a:prstGeom prst="rect">
              <a:avLst/>
            </a:prstGeom>
          </p:spPr>
        </p:pic>
        <p:sp>
          <p:nvSpPr>
            <p:cNvPr id="6" name="矩形 5"/>
            <p:cNvSpPr/>
            <p:nvPr/>
          </p:nvSpPr>
          <p:spPr>
            <a:xfrm>
              <a:off x="1745757" y="5947295"/>
              <a:ext cx="288032" cy="288032"/>
            </a:xfrm>
            <a:prstGeom prst="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右箭头 5"/>
            <p:cNvSpPr/>
            <p:nvPr/>
          </p:nvSpPr>
          <p:spPr>
            <a:xfrm>
              <a:off x="2148561" y="6031573"/>
              <a:ext cx="342203" cy="152836"/>
            </a:xfrm>
            <a:prstGeom prst="rightArrow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Picture 3" descr="F:\桌面文件\图片\透射电镜\WT-2\Img9658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/>
            <a:stretch>
              <a:fillRect/>
            </a:stretch>
          </p:blipFill>
          <p:spPr bwMode="auto">
            <a:xfrm>
              <a:off x="1130872" y="4567236"/>
              <a:ext cx="1293620" cy="9324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" name="矩形 8"/>
            <p:cNvSpPr/>
            <p:nvPr/>
          </p:nvSpPr>
          <p:spPr>
            <a:xfrm>
              <a:off x="1556792" y="4876184"/>
              <a:ext cx="432048" cy="343888"/>
            </a:xfrm>
            <a:prstGeom prst="rect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右箭头 5"/>
            <p:cNvSpPr/>
            <p:nvPr/>
          </p:nvSpPr>
          <p:spPr>
            <a:xfrm>
              <a:off x="2158717" y="4971710"/>
              <a:ext cx="342203" cy="152836"/>
            </a:xfrm>
            <a:prstGeom prst="rightArrow">
              <a:avLst/>
            </a:prstGeom>
            <a:noFill/>
            <a:ln w="635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472014" y="881769"/>
            <a:ext cx="33534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6"/>
          <p:cNvSpPr txBox="1"/>
          <p:nvPr/>
        </p:nvSpPr>
        <p:spPr>
          <a:xfrm>
            <a:off x="372628" y="1846822"/>
            <a:ext cx="43473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750" i="1" dirty="0" smtClean="0"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lmm9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/>
          <p:cNvGrpSpPr>
            <a:grpSpLocks noChangeAspect="1"/>
          </p:cNvGrpSpPr>
          <p:nvPr/>
        </p:nvGrpSpPr>
        <p:grpSpPr>
          <a:xfrm>
            <a:off x="785378" y="553817"/>
            <a:ext cx="1408919" cy="933128"/>
            <a:chOff x="1052736" y="3898274"/>
            <a:chExt cx="3300456" cy="2185893"/>
          </a:xfrm>
        </p:grpSpPr>
        <p:pic>
          <p:nvPicPr>
            <p:cNvPr id="28" name="图片 27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25" t="13357" r="3843" b="10744"/>
            <a:stretch>
              <a:fillRect/>
            </a:stretch>
          </p:blipFill>
          <p:spPr>
            <a:xfrm>
              <a:off x="1052736" y="3898274"/>
              <a:ext cx="3300456" cy="2185893"/>
            </a:xfrm>
            <a:prstGeom prst="rect">
              <a:avLst/>
            </a:prstGeom>
          </p:spPr>
        </p:pic>
        <p:cxnSp>
          <p:nvCxnSpPr>
            <p:cNvPr id="29" name="直接连接符 28"/>
            <p:cNvCxnSpPr/>
            <p:nvPr/>
          </p:nvCxnSpPr>
          <p:spPr>
            <a:xfrm>
              <a:off x="3541440" y="6012160"/>
              <a:ext cx="738000" cy="0"/>
            </a:xfrm>
            <a:prstGeom prst="line">
              <a:avLst/>
            </a:prstGeom>
            <a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tile tx="0" ty="0" sx="100000" sy="100000" flip="none" algn="tl"/>
            </a:blipFill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矩形 17"/>
          <p:cNvSpPr>
            <a:spLocks noChangeAspect="1"/>
          </p:cNvSpPr>
          <p:nvPr/>
        </p:nvSpPr>
        <p:spPr>
          <a:xfrm>
            <a:off x="944344" y="1195380"/>
            <a:ext cx="180000" cy="129500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/>
          <p:cNvGrpSpPr>
            <a:grpSpLocks noChangeAspect="1"/>
          </p:cNvGrpSpPr>
          <p:nvPr/>
        </p:nvGrpSpPr>
        <p:grpSpPr>
          <a:xfrm>
            <a:off x="785378" y="1520314"/>
            <a:ext cx="1408919" cy="933128"/>
            <a:chOff x="192612" y="2267741"/>
            <a:chExt cx="2935553" cy="1944217"/>
          </a:xfrm>
        </p:grpSpPr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0000" contrast="20000"/>
                      </a14:imgEffect>
                      <a14:imgEffect>
                        <a14:saturation sat="4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2" t="14512" r="3344" b="8336"/>
            <a:stretch>
              <a:fillRect/>
            </a:stretch>
          </p:blipFill>
          <p:spPr>
            <a:xfrm>
              <a:off x="192612" y="2267741"/>
              <a:ext cx="2935553" cy="1944217"/>
            </a:xfrm>
            <a:prstGeom prst="rect">
              <a:avLst/>
            </a:prstGeom>
          </p:spPr>
        </p:pic>
        <p:cxnSp>
          <p:nvCxnSpPr>
            <p:cNvPr id="27" name="直接连接符 26"/>
            <p:cNvCxnSpPr/>
            <p:nvPr/>
          </p:nvCxnSpPr>
          <p:spPr>
            <a:xfrm>
              <a:off x="2234838" y="4148850"/>
              <a:ext cx="77760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组合 20"/>
          <p:cNvGrpSpPr>
            <a:grpSpLocks noChangeAspect="1"/>
          </p:cNvGrpSpPr>
          <p:nvPr/>
        </p:nvGrpSpPr>
        <p:grpSpPr>
          <a:xfrm>
            <a:off x="2219550" y="1523014"/>
            <a:ext cx="1295331" cy="933129"/>
            <a:chOff x="3780589" y="2234699"/>
            <a:chExt cx="2744751" cy="1977259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3" t="10117" r="4326" b="11420"/>
            <a:stretch>
              <a:fillRect/>
            </a:stretch>
          </p:blipFill>
          <p:spPr>
            <a:xfrm>
              <a:off x="3780589" y="2234699"/>
              <a:ext cx="2744751" cy="1977259"/>
            </a:xfrm>
            <a:prstGeom prst="rect">
              <a:avLst/>
            </a:prstGeom>
          </p:spPr>
        </p:pic>
        <p:cxnSp>
          <p:nvCxnSpPr>
            <p:cNvPr id="25" name="直接连接符 24"/>
            <p:cNvCxnSpPr/>
            <p:nvPr/>
          </p:nvCxnSpPr>
          <p:spPr>
            <a:xfrm>
              <a:off x="5857973" y="4139952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矩形 21"/>
          <p:cNvSpPr/>
          <p:nvPr/>
        </p:nvSpPr>
        <p:spPr>
          <a:xfrm>
            <a:off x="1478002" y="2004535"/>
            <a:ext cx="353552" cy="35405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右箭头 5"/>
          <p:cNvSpPr/>
          <p:nvPr/>
        </p:nvSpPr>
        <p:spPr>
          <a:xfrm>
            <a:off x="1986539" y="2144282"/>
            <a:ext cx="342203" cy="152836"/>
          </a:xfrm>
          <a:prstGeom prst="rightArrow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52"/>
          <p:cNvSpPr txBox="1"/>
          <p:nvPr/>
        </p:nvSpPr>
        <p:spPr>
          <a:xfrm>
            <a:off x="2186881" y="1670975"/>
            <a:ext cx="31931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g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53"/>
          <p:cNvSpPr txBox="1"/>
          <p:nvPr/>
        </p:nvSpPr>
        <p:spPr>
          <a:xfrm>
            <a:off x="2508034" y="1601735"/>
            <a:ext cx="30809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54"/>
          <p:cNvSpPr txBox="1"/>
          <p:nvPr/>
        </p:nvSpPr>
        <p:spPr>
          <a:xfrm>
            <a:off x="733586" y="1821985"/>
            <a:ext cx="31290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55"/>
          <p:cNvSpPr txBox="1"/>
          <p:nvPr/>
        </p:nvSpPr>
        <p:spPr>
          <a:xfrm>
            <a:off x="1382411" y="1197315"/>
            <a:ext cx="31290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07547" y="4947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711943" y="147803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000" b="1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53013" y="1478039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000" b="1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4531168" y="1425467"/>
            <a:ext cx="252000" cy="0"/>
          </a:xfrm>
          <a:prstGeom prst="line">
            <a:avLst/>
          </a:prstGeom>
          <a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0" ty="0" sx="100000" sy="100000" flip="none" algn="tl"/>
          </a:blip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4552990" y="2432804"/>
            <a:ext cx="252000" cy="0"/>
          </a:xfrm>
          <a:prstGeom prst="line">
            <a:avLst/>
          </a:prstGeom>
          <a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0" ty="0" sx="100000" sy="100000" flip="none" algn="tl"/>
          </a:blip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3492681" y="49470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811733" y="49470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3517108" y="147803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855191" y="1478039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000" b="1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56"/>
          <p:cNvSpPr txBox="1"/>
          <p:nvPr/>
        </p:nvSpPr>
        <p:spPr>
          <a:xfrm>
            <a:off x="4069499" y="915189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56"/>
          <p:cNvSpPr txBox="1"/>
          <p:nvPr/>
        </p:nvSpPr>
        <p:spPr>
          <a:xfrm>
            <a:off x="5644481" y="873336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56"/>
          <p:cNvSpPr txBox="1"/>
          <p:nvPr/>
        </p:nvSpPr>
        <p:spPr>
          <a:xfrm>
            <a:off x="4489547" y="2112452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56"/>
          <p:cNvSpPr txBox="1"/>
          <p:nvPr/>
        </p:nvSpPr>
        <p:spPr>
          <a:xfrm>
            <a:off x="4186456" y="2008139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56"/>
          <p:cNvSpPr txBox="1"/>
          <p:nvPr/>
        </p:nvSpPr>
        <p:spPr>
          <a:xfrm>
            <a:off x="3804683" y="2119078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56"/>
          <p:cNvSpPr txBox="1"/>
          <p:nvPr/>
        </p:nvSpPr>
        <p:spPr>
          <a:xfrm>
            <a:off x="5287336" y="1670975"/>
            <a:ext cx="26481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861465" y="1343145"/>
            <a:ext cx="34015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141850" y="1135127"/>
            <a:ext cx="29206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IM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接箭头连接符 66"/>
          <p:cNvCxnSpPr>
            <a:cxnSpLocks noChangeAspect="1"/>
          </p:cNvCxnSpPr>
          <p:nvPr/>
        </p:nvCxnSpPr>
        <p:spPr>
          <a:xfrm flipH="1">
            <a:off x="5177483" y="1283142"/>
            <a:ext cx="54000" cy="67429"/>
          </a:xfrm>
          <a:prstGeom prst="straightConnector1">
            <a:avLst/>
          </a:prstGeom>
          <a:ln w="6350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箭头连接符 68"/>
          <p:cNvCxnSpPr>
            <a:cxnSpLocks noChangeAspect="1"/>
          </p:cNvCxnSpPr>
          <p:nvPr/>
        </p:nvCxnSpPr>
        <p:spPr>
          <a:xfrm rot="10800000" flipH="1">
            <a:off x="5080828" y="1338090"/>
            <a:ext cx="54000" cy="54000"/>
          </a:xfrm>
          <a:prstGeom prst="straightConnector1">
            <a:avLst/>
          </a:prstGeom>
          <a:ln w="6350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5177483" y="743867"/>
            <a:ext cx="29046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箭头连接符 71"/>
          <p:cNvCxnSpPr>
            <a:cxnSpLocks noChangeAspect="1"/>
          </p:cNvCxnSpPr>
          <p:nvPr/>
        </p:nvCxnSpPr>
        <p:spPr>
          <a:xfrm flipH="1">
            <a:off x="5211590" y="887430"/>
            <a:ext cx="54000" cy="67429"/>
          </a:xfrm>
          <a:prstGeom prst="straightConnector1">
            <a:avLst/>
          </a:prstGeom>
          <a:ln w="6350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文本框 55"/>
          <p:cNvSpPr txBox="1"/>
          <p:nvPr/>
        </p:nvSpPr>
        <p:spPr>
          <a:xfrm>
            <a:off x="4304824" y="1655586"/>
            <a:ext cx="31290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p</a:t>
            </a:r>
            <a:endParaRPr lang="zh-CN" altLang="en-US" sz="7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977023" y="1807697"/>
            <a:ext cx="29046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接箭头连接符 98"/>
          <p:cNvCxnSpPr>
            <a:cxnSpLocks noChangeAspect="1"/>
          </p:cNvCxnSpPr>
          <p:nvPr/>
        </p:nvCxnSpPr>
        <p:spPr>
          <a:xfrm flipH="1">
            <a:off x="5016222" y="1950512"/>
            <a:ext cx="54000" cy="67429"/>
          </a:xfrm>
          <a:prstGeom prst="straightConnector1">
            <a:avLst/>
          </a:prstGeom>
          <a:ln w="6350">
            <a:solidFill>
              <a:schemeClr val="tx1"/>
            </a:solidFill>
            <a:headEnd type="none"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5585130" y="1435478"/>
            <a:ext cx="360000" cy="0"/>
          </a:xfrm>
          <a:prstGeom prst="line">
            <a:avLst/>
          </a:prstGeom>
          <a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0" ty="0" sx="100000" sy="100000" flip="none" algn="tl"/>
          </a:blip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5585130" y="2425184"/>
            <a:ext cx="360000" cy="0"/>
          </a:xfrm>
          <a:prstGeom prst="line">
            <a:avLst/>
          </a:prstGeom>
          <a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tile tx="0" ty="0" sx="100000" sy="100000" flip="none" algn="tl"/>
          </a:blipFill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5" name="组合 84"/>
          <p:cNvGrpSpPr>
            <a:grpSpLocks noChangeAspect="1"/>
          </p:cNvGrpSpPr>
          <p:nvPr/>
        </p:nvGrpSpPr>
        <p:grpSpPr>
          <a:xfrm>
            <a:off x="2218663" y="554137"/>
            <a:ext cx="1296000" cy="933128"/>
            <a:chOff x="2108200" y="2680193"/>
            <a:chExt cx="2451100" cy="1764807"/>
          </a:xfrm>
        </p:grpSpPr>
        <p:pic>
          <p:nvPicPr>
            <p:cNvPr id="86" name="Picture 2" descr="F:\桌面文件\图片\透射电镜\WT\Img8664.tif"/>
            <p:cNvPicPr>
              <a:picLocks noChangeAspect="1" noChangeArrowheads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019" t="24839" r="7330" b="5203"/>
            <a:stretch>
              <a:fillRect/>
            </a:stretch>
          </p:blipFill>
          <p:spPr bwMode="auto">
            <a:xfrm>
              <a:off x="2108200" y="2680193"/>
              <a:ext cx="2451100" cy="176480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87" name="直接连接符 86"/>
            <p:cNvCxnSpPr/>
            <p:nvPr/>
          </p:nvCxnSpPr>
          <p:spPr>
            <a:xfrm>
              <a:off x="3886808" y="4355976"/>
              <a:ext cx="64771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文本框 56"/>
          <p:cNvSpPr txBox="1"/>
          <p:nvPr/>
        </p:nvSpPr>
        <p:spPr>
          <a:xfrm>
            <a:off x="2865008" y="987378"/>
            <a:ext cx="30809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49"/>
          <p:cNvSpPr txBox="1"/>
          <p:nvPr/>
        </p:nvSpPr>
        <p:spPr>
          <a:xfrm>
            <a:off x="2424480" y="920673"/>
            <a:ext cx="356188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>
                <a:solidFill>
                  <a:schemeClr val="bg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y</a:t>
            </a:r>
            <a:endParaRPr lang="zh-CN" altLang="en-US" sz="750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49"/>
          <p:cNvSpPr txBox="1"/>
          <p:nvPr/>
        </p:nvSpPr>
        <p:spPr>
          <a:xfrm>
            <a:off x="2270795" y="1187433"/>
            <a:ext cx="344966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W</a:t>
            </a:r>
            <a:endParaRPr lang="zh-CN" altLang="en-US" sz="750" dirty="0">
              <a:solidFill>
                <a:schemeClr val="bg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174560" y="494703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右箭头 18"/>
          <p:cNvSpPr/>
          <p:nvPr/>
        </p:nvSpPr>
        <p:spPr>
          <a:xfrm>
            <a:off x="1986539" y="1272631"/>
            <a:ext cx="342203" cy="152836"/>
          </a:xfrm>
          <a:prstGeom prst="rightArrow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1888738" y="2555776"/>
            <a:ext cx="2453263" cy="2245841"/>
            <a:chOff x="1753612" y="2627784"/>
            <a:chExt cx="2453263" cy="2245841"/>
          </a:xfrm>
        </p:grpSpPr>
        <p:sp>
          <p:nvSpPr>
            <p:cNvPr id="66" name="TextBox 65"/>
            <p:cNvSpPr txBox="1"/>
            <p:nvPr/>
          </p:nvSpPr>
          <p:spPr>
            <a:xfrm>
              <a:off x="1753612" y="2627784"/>
              <a:ext cx="21993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3" name="对象 12"/>
            <p:cNvGraphicFramePr>
              <a:graphicFrameLocks noChangeAspect="1"/>
            </p:cNvGraphicFramePr>
            <p:nvPr/>
          </p:nvGraphicFramePr>
          <p:xfrm>
            <a:off x="2035175" y="2700338"/>
            <a:ext cx="2171700" cy="21732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5719" name="Prism 8" r:id="rId11" imgW="4010025" imgH="4019550" progId="Prism8.Document">
                    <p:embed/>
                  </p:oleObj>
                </mc:Choice>
                <mc:Fallback>
                  <p:oleObj name="Prism 8" r:id="rId11" imgW="4010025" imgH="4019550" progId="Prism8.Document">
                    <p:embed/>
                    <p:pic>
                      <p:nvPicPr>
                        <p:cNvPr id="0" name="图片 2571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2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2035175" y="2700338"/>
                          <a:ext cx="2171700" cy="21732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矩形 15"/>
            <p:cNvSpPr/>
            <p:nvPr/>
          </p:nvSpPr>
          <p:spPr>
            <a:xfrm rot="16200000">
              <a:off x="1050343" y="3645144"/>
              <a:ext cx="1957275" cy="2077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750" dirty="0">
                  <a:latin typeface="Arial" panose="020B0604020202020204"/>
                </a:rPr>
                <a:t>Photosynthetic pigment contents (mg/g)</a:t>
              </a:r>
              <a:endParaRPr lang="zh-CN" altLang="en-US" sz="750" dirty="0">
                <a:latin typeface="Arial" panose="020B0604020202020204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175690" y="2800400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175690" y="3395696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175690" y="3990992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175690" y="4586289"/>
              <a:ext cx="52900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603942" y="2750303"/>
              <a:ext cx="335348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559043" y="2915816"/>
              <a:ext cx="43473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m9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340890" y="4711736"/>
              <a:ext cx="22281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a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755254" y="4711736"/>
              <a:ext cx="22281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b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195936" y="4711736"/>
              <a:ext cx="331822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hl</a:t>
              </a:r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+b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3669508" y="4711736"/>
              <a:ext cx="158698" cy="115416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r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415456" y="3744504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842195" y="4262760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3281902" y="3511112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3700347" y="4249622"/>
              <a:ext cx="258404" cy="20774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75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zh-CN" altLang="en-US" sz="75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TextBox 50"/>
          <p:cNvSpPr txBox="1"/>
          <p:nvPr/>
        </p:nvSpPr>
        <p:spPr>
          <a:xfrm>
            <a:off x="3480540" y="25152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3754614" y="567747"/>
            <a:ext cx="6033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Picture 3" descr="D:\2024下\0820ubi.jpg"/>
          <p:cNvPicPr>
            <a:picLocks noChangeAspect="1" noChangeArrowheads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2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470" t="59100" r="68499" b="36790"/>
          <a:stretch>
            <a:fillRect/>
          </a:stretch>
        </p:blipFill>
        <p:spPr bwMode="auto">
          <a:xfrm>
            <a:off x="3700514" y="593276"/>
            <a:ext cx="1620000" cy="2054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3" descr="D:\2024下\0820ubi.jpg"/>
          <p:cNvPicPr>
            <a:picLocks noChangeAspect="1" noChangeArrowheads="1"/>
          </p:cNvPicPr>
          <p:nvPr/>
        </p:nvPicPr>
        <p:blipFill rotWithShape="1"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2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4009" t="59400" r="39960" b="36491"/>
          <a:stretch>
            <a:fillRect/>
          </a:stretch>
        </p:blipFill>
        <p:spPr bwMode="auto">
          <a:xfrm>
            <a:off x="3700514" y="834602"/>
            <a:ext cx="1620000" cy="2054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4" descr="D:\2024下\0820g892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104" t="54714" r="36583" b="40619"/>
          <a:stretch>
            <a:fillRect/>
          </a:stretch>
        </p:blipFill>
        <p:spPr bwMode="auto">
          <a:xfrm>
            <a:off x="3700514" y="1113315"/>
            <a:ext cx="1620000" cy="208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4" descr="D:\2024下\0820g892R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820" t="54223" r="6867" b="40702"/>
          <a:stretch>
            <a:fillRect/>
          </a:stretch>
        </p:blipFill>
        <p:spPr bwMode="auto">
          <a:xfrm>
            <a:off x="3700514" y="1358957"/>
            <a:ext cx="1620000" cy="2268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" name="Picture 5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567" t="62756" r="38377" b="33048"/>
          <a:stretch>
            <a:fillRect/>
          </a:stretch>
        </p:blipFill>
        <p:spPr bwMode="auto">
          <a:xfrm>
            <a:off x="3700514" y="1649661"/>
            <a:ext cx="1620000" cy="2008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Picture 5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849" t="62715" r="9095" b="32693"/>
          <a:stretch>
            <a:fillRect/>
          </a:stretch>
        </p:blipFill>
        <p:spPr bwMode="auto">
          <a:xfrm>
            <a:off x="3700514" y="1883293"/>
            <a:ext cx="1620000" cy="2197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3" name="Picture 6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9365" t="51981" r="14530" b="43672"/>
          <a:stretch>
            <a:fillRect/>
          </a:stretch>
        </p:blipFill>
        <p:spPr bwMode="auto">
          <a:xfrm>
            <a:off x="3700514" y="2422180"/>
            <a:ext cx="1620000" cy="2149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4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379" t="51095" r="42516" b="44558"/>
          <a:stretch>
            <a:fillRect/>
          </a:stretch>
        </p:blipFill>
        <p:spPr bwMode="auto">
          <a:xfrm>
            <a:off x="3700514" y="2171042"/>
            <a:ext cx="1620000" cy="2149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5" name="TextBox 44"/>
          <p:cNvSpPr txBox="1"/>
          <p:nvPr/>
        </p:nvSpPr>
        <p:spPr>
          <a:xfrm>
            <a:off x="5871319" y="773969"/>
            <a:ext cx="349455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Ubiqutin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871319" y="1290868"/>
            <a:ext cx="546625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Os03g03450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871319" y="1834336"/>
            <a:ext cx="654025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Os03g03450.1 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871319" y="2355363"/>
            <a:ext cx="654025" cy="126958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Os03g03450.2 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4420098" y="567747"/>
            <a:ext cx="60332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矩形 51"/>
          <p:cNvSpPr/>
          <p:nvPr/>
        </p:nvSpPr>
        <p:spPr>
          <a:xfrm>
            <a:off x="5369318" y="646739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28 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5369318" y="866874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3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/>
          <p:cNvCxnSpPr/>
          <p:nvPr/>
        </p:nvCxnSpPr>
        <p:spPr>
          <a:xfrm>
            <a:off x="5827644" y="683568"/>
            <a:ext cx="0" cy="288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矩形 54"/>
          <p:cNvSpPr/>
          <p:nvPr/>
        </p:nvSpPr>
        <p:spPr>
          <a:xfrm>
            <a:off x="5369318" y="1155837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3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5369318" y="1409691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8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直接连接符 56"/>
          <p:cNvCxnSpPr/>
          <p:nvPr/>
        </p:nvCxnSpPr>
        <p:spPr>
          <a:xfrm>
            <a:off x="5827644" y="1189123"/>
            <a:ext cx="0" cy="33517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矩形 57"/>
          <p:cNvSpPr/>
          <p:nvPr/>
        </p:nvSpPr>
        <p:spPr>
          <a:xfrm>
            <a:off x="5369318" y="1692193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3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5369318" y="1933348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8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接连接符 59"/>
          <p:cNvCxnSpPr/>
          <p:nvPr/>
        </p:nvCxnSpPr>
        <p:spPr>
          <a:xfrm>
            <a:off x="5827644" y="1719155"/>
            <a:ext cx="0" cy="32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矩形 60"/>
          <p:cNvSpPr/>
          <p:nvPr/>
        </p:nvSpPr>
        <p:spPr>
          <a:xfrm>
            <a:off x="5369318" y="2220854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3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5369318" y="2462896"/>
            <a:ext cx="39914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8 cycles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直接连接符 62"/>
          <p:cNvCxnSpPr/>
          <p:nvPr/>
        </p:nvCxnSpPr>
        <p:spPr>
          <a:xfrm>
            <a:off x="5827644" y="2254587"/>
            <a:ext cx="0" cy="324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3999111" y="416701"/>
            <a:ext cx="15068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607434" y="416701"/>
            <a:ext cx="23403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500830" y="3019384"/>
            <a:ext cx="582731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total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03g0345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03g03450.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03g03450.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WT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quence comparison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1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2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ear the last exon region.  The coding sequences of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1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2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re uppercased in red and blue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spectively. Arrows indicate the primers used for analyzing the gene expression of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QLMM9-F/QLMM9-R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1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QLMM9-F/QLMM9-1R), and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2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(QLMM9-F/QLMM9-2R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ene expression of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s03g03450.1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s03g03450.2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aves of WT 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utant at adult stage. </a:t>
            </a:r>
            <a:endParaRPr lang="zh-CN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5102184" y="416701"/>
            <a:ext cx="179536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altLang="zh-CN" sz="75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77993" y="25152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0" name="组合 79"/>
          <p:cNvGrpSpPr/>
          <p:nvPr/>
        </p:nvGrpSpPr>
        <p:grpSpPr>
          <a:xfrm>
            <a:off x="410273" y="512294"/>
            <a:ext cx="612347" cy="213444"/>
            <a:chOff x="-123961" y="3881285"/>
            <a:chExt cx="612347" cy="213444"/>
          </a:xfrm>
        </p:grpSpPr>
        <p:sp>
          <p:nvSpPr>
            <p:cNvPr id="81" name="TextBox 80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sp>
        <p:nvSpPr>
          <p:cNvPr id="83" name="矩形 82"/>
          <p:cNvSpPr/>
          <p:nvPr/>
        </p:nvSpPr>
        <p:spPr>
          <a:xfrm>
            <a:off x="952127" y="485059"/>
            <a:ext cx="41710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00" b="1" dirty="0">
                <a:solidFill>
                  <a:srgbClr val="00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r>
              <a:rPr lang="en-US" altLang="zh-CN" sz="600" b="1" dirty="0">
                <a:solidFill>
                  <a:srgbClr val="FF0000"/>
                </a:solidFill>
                <a:latin typeface="Courier New" panose="02070309020205020404"/>
                <a:cs typeface="宋体" panose="02010600030101010101" pitchFamily="2" charset="-122"/>
              </a:rPr>
              <a:t>--- </a:t>
            </a:r>
            <a:endParaRPr lang="zh-CN" altLang="en-US" sz="600" b="1" dirty="0">
              <a:solidFill>
                <a:srgbClr val="FF0000"/>
              </a:solidFill>
            </a:endParaRPr>
          </a:p>
        </p:txBody>
      </p:sp>
      <p:sp>
        <p:nvSpPr>
          <p:cNvPr id="84" name="矩形 83"/>
          <p:cNvSpPr/>
          <p:nvPr/>
        </p:nvSpPr>
        <p:spPr>
          <a:xfrm>
            <a:off x="945777" y="573073"/>
            <a:ext cx="41710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00" b="1" dirty="0">
                <a:solidFill>
                  <a:srgbClr val="00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r>
              <a:rPr lang="en-US" altLang="zh-CN" sz="600" b="1" dirty="0">
                <a:solidFill>
                  <a:schemeClr val="accent1">
                    <a:lumMod val="75000"/>
                  </a:schemeClr>
                </a:solidFill>
                <a:latin typeface="Courier New" panose="02070309020205020404"/>
                <a:cs typeface="宋体" panose="02010600030101010101" pitchFamily="2" charset="-122"/>
              </a:rPr>
              <a:t>---</a:t>
            </a:r>
            <a:r>
              <a:rPr lang="en-US" altLang="zh-CN" sz="600" b="1" dirty="0">
                <a:solidFill>
                  <a:srgbClr val="FF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endParaRPr lang="zh-CN" altLang="en-US" sz="600" b="1" dirty="0">
              <a:solidFill>
                <a:srgbClr val="FF0000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675766" y="1698517"/>
            <a:ext cx="355867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dirty="0" smtClean="0">
                <a:solidFill>
                  <a:srgbClr val="05CB0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LMM9-R</a:t>
            </a:r>
            <a:endParaRPr lang="zh-CN" altLang="en-US" sz="600" dirty="0">
              <a:solidFill>
                <a:srgbClr val="05CB0E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166326" y="747382"/>
            <a:ext cx="347852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dirty="0" smtClean="0">
                <a:solidFill>
                  <a:srgbClr val="05CB0E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LMM9-F</a:t>
            </a:r>
            <a:endParaRPr lang="zh-CN" altLang="en-US" sz="600" dirty="0">
              <a:solidFill>
                <a:srgbClr val="05CB0E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7" name="直接连接符 86"/>
          <p:cNvCxnSpPr/>
          <p:nvPr/>
        </p:nvCxnSpPr>
        <p:spPr>
          <a:xfrm flipV="1">
            <a:off x="2903375" y="520509"/>
            <a:ext cx="576000" cy="0"/>
          </a:xfrm>
          <a:prstGeom prst="line">
            <a:avLst/>
          </a:prstGeom>
          <a:ln>
            <a:solidFill>
              <a:srgbClr val="05CB0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矩形 87"/>
          <p:cNvSpPr/>
          <p:nvPr/>
        </p:nvSpPr>
        <p:spPr>
          <a:xfrm>
            <a:off x="981481" y="417309"/>
            <a:ext cx="2602753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164465">
              <a:lnSpc>
                <a:spcPct val="280000"/>
              </a:lnSpc>
            </a:pPr>
            <a:r>
              <a:rPr lang="en-US" sz="750" b="1" kern="1200" dirty="0" smtClean="0">
                <a:solidFill>
                  <a:srgbClr val="0070C0"/>
                </a:solidFill>
                <a:effectLst/>
                <a:latin typeface="Courier New" panose="02070309020205020404"/>
                <a:cs typeface="宋体" panose="02010600030101010101" pitchFamily="2" charset="-122"/>
              </a:rPr>
              <a:t>GTTCTTGCTGGTCAAAGAGGTTCAATTGCTGATGCTCTCGTGCTGAATGCTGCAGCATCTCTTCTTGTCAGTGGTAAAGTAAATACTTTGCATGATGGTGTAGCGTTAGCACAGGAAACACAACGCTCCGGGGAGGCCATCAACACACTTGAATCCTGGATAAAGATTTCCAATGTAAGTACTTCTGATAATTAA</a:t>
            </a:r>
            <a:r>
              <a:rPr lang="en-US" sz="750" b="1" kern="1200" dirty="0" smtClean="0">
                <a:solidFill>
                  <a:srgbClr val="000000"/>
                </a:solidFill>
                <a:effectLst/>
                <a:latin typeface="Courier New" panose="02070309020205020404"/>
                <a:cs typeface="宋体" panose="02010600030101010101" pitchFamily="2" charset="-122"/>
              </a:rPr>
              <a:t>tatttgcaaagcacattttgtctgtcagctaaatatgaatctgacgccctccggaaaattgttgatacagagttgctgagactgatgtt</a:t>
            </a:r>
            <a:r>
              <a:rPr lang="en-US" altLang="zh-CN" sz="750" b="1" dirty="0" smtClean="0">
                <a:latin typeface="Courier New" panose="02070309020205020404"/>
                <a:cs typeface="宋体" panose="02010600030101010101" pitchFamily="2" charset="-122"/>
              </a:rPr>
              <a:t>ggtt</a:t>
            </a:r>
            <a:endParaRPr lang="zh-CN" altLang="zh-CN" sz="1200" dirty="0">
              <a:latin typeface="宋体" panose="02010600030101010101" pitchFamily="2" charset="-122"/>
              <a:cs typeface="宋体" panose="02010600030101010101" pitchFamily="2" charset="-122"/>
            </a:endParaRPr>
          </a:p>
        </p:txBody>
      </p:sp>
      <p:cxnSp>
        <p:nvCxnSpPr>
          <p:cNvPr id="89" name="直接连接符 88"/>
          <p:cNvCxnSpPr/>
          <p:nvPr/>
        </p:nvCxnSpPr>
        <p:spPr>
          <a:xfrm flipV="1">
            <a:off x="1078856" y="836048"/>
            <a:ext cx="558000" cy="0"/>
          </a:xfrm>
          <a:prstGeom prst="line">
            <a:avLst/>
          </a:prstGeom>
          <a:ln>
            <a:solidFill>
              <a:srgbClr val="05CB0E"/>
            </a:solidFill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/>
          <p:cNvCxnSpPr/>
          <p:nvPr/>
        </p:nvCxnSpPr>
        <p:spPr>
          <a:xfrm flipH="1" flipV="1">
            <a:off x="2219822" y="1703808"/>
            <a:ext cx="1260000" cy="0"/>
          </a:xfrm>
          <a:prstGeom prst="line">
            <a:avLst/>
          </a:prstGeom>
          <a:ln>
            <a:solidFill>
              <a:srgbClr val="05CB0E"/>
            </a:solidFill>
            <a:headEnd type="none"/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/>
          <p:cNvCxnSpPr/>
          <p:nvPr/>
        </p:nvCxnSpPr>
        <p:spPr>
          <a:xfrm>
            <a:off x="1069454" y="2016562"/>
            <a:ext cx="108000" cy="0"/>
          </a:xfrm>
          <a:prstGeom prst="line">
            <a:avLst/>
          </a:prstGeom>
          <a:ln>
            <a:solidFill>
              <a:srgbClr val="05CB0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647473" y="2350815"/>
            <a:ext cx="394339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600" dirty="0" smtClean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LMM9-2R</a:t>
            </a:r>
            <a:endParaRPr lang="zh-CN" altLang="en-US" sz="600" dirty="0">
              <a:solidFill>
                <a:schemeClr val="accent1">
                  <a:lumMod val="75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接连接符 92"/>
          <p:cNvCxnSpPr/>
          <p:nvPr/>
        </p:nvCxnSpPr>
        <p:spPr>
          <a:xfrm flipH="1">
            <a:off x="2441080" y="2349373"/>
            <a:ext cx="1026000" cy="0"/>
          </a:xfrm>
          <a:prstGeom prst="line">
            <a:avLst/>
          </a:prstGeom>
          <a:ln>
            <a:solidFill>
              <a:schemeClr val="tx2">
                <a:lumMod val="60000"/>
                <a:lumOff val="40000"/>
              </a:schemeClr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 flipH="1">
            <a:off x="1977944" y="2452966"/>
            <a:ext cx="79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1126295" y="1702003"/>
            <a:ext cx="394339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LMM9-1R</a:t>
            </a:r>
            <a:endParaRPr lang="zh-CN" altLang="en-US" sz="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直接连接符 95"/>
          <p:cNvCxnSpPr/>
          <p:nvPr/>
        </p:nvCxnSpPr>
        <p:spPr>
          <a:xfrm flipH="1">
            <a:off x="1063933" y="1802364"/>
            <a:ext cx="5220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/>
          <p:cNvCxnSpPr/>
          <p:nvPr/>
        </p:nvCxnSpPr>
        <p:spPr>
          <a:xfrm flipH="1">
            <a:off x="3362265" y="1459065"/>
            <a:ext cx="108000" cy="0"/>
          </a:xfrm>
          <a:prstGeom prst="line">
            <a:avLst/>
          </a:prstGeom>
          <a:ln>
            <a:solidFill>
              <a:srgbClr val="FF0000"/>
            </a:solidFill>
            <a:tail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8" name="组合 97"/>
          <p:cNvGrpSpPr/>
          <p:nvPr/>
        </p:nvGrpSpPr>
        <p:grpSpPr>
          <a:xfrm>
            <a:off x="410273" y="1483983"/>
            <a:ext cx="612347" cy="213444"/>
            <a:chOff x="-123961" y="3881285"/>
            <a:chExt cx="612347" cy="213444"/>
          </a:xfrm>
        </p:grpSpPr>
        <p:sp>
          <p:nvSpPr>
            <p:cNvPr id="99" name="TextBox 98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01" name="组合 100"/>
          <p:cNvGrpSpPr/>
          <p:nvPr/>
        </p:nvGrpSpPr>
        <p:grpSpPr>
          <a:xfrm>
            <a:off x="410273" y="1803820"/>
            <a:ext cx="612347" cy="213444"/>
            <a:chOff x="-123961" y="3881285"/>
            <a:chExt cx="612347" cy="213444"/>
          </a:xfrm>
        </p:grpSpPr>
        <p:sp>
          <p:nvSpPr>
            <p:cNvPr id="102" name="TextBox 101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04" name="组合 103"/>
          <p:cNvGrpSpPr/>
          <p:nvPr/>
        </p:nvGrpSpPr>
        <p:grpSpPr>
          <a:xfrm>
            <a:off x="410273" y="2123657"/>
            <a:ext cx="612347" cy="213444"/>
            <a:chOff x="-123961" y="3881285"/>
            <a:chExt cx="612347" cy="213444"/>
          </a:xfrm>
        </p:grpSpPr>
        <p:sp>
          <p:nvSpPr>
            <p:cNvPr id="105" name="TextBox 104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07" name="组合 106"/>
          <p:cNvGrpSpPr/>
          <p:nvPr/>
        </p:nvGrpSpPr>
        <p:grpSpPr>
          <a:xfrm>
            <a:off x="410273" y="2443493"/>
            <a:ext cx="612347" cy="213444"/>
            <a:chOff x="-123961" y="3881285"/>
            <a:chExt cx="612347" cy="213444"/>
          </a:xfrm>
        </p:grpSpPr>
        <p:sp>
          <p:nvSpPr>
            <p:cNvPr id="108" name="TextBox 107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11" name="组合 110"/>
          <p:cNvGrpSpPr/>
          <p:nvPr/>
        </p:nvGrpSpPr>
        <p:grpSpPr>
          <a:xfrm>
            <a:off x="410273" y="1164146"/>
            <a:ext cx="612347" cy="213444"/>
            <a:chOff x="-123961" y="3881285"/>
            <a:chExt cx="612347" cy="213444"/>
          </a:xfrm>
        </p:grpSpPr>
        <p:sp>
          <p:nvSpPr>
            <p:cNvPr id="112" name="TextBox 111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grpSp>
        <p:nvGrpSpPr>
          <p:cNvPr id="114" name="组合 113"/>
          <p:cNvGrpSpPr/>
          <p:nvPr/>
        </p:nvGrpSpPr>
        <p:grpSpPr>
          <a:xfrm>
            <a:off x="410273" y="844309"/>
            <a:ext cx="612347" cy="213444"/>
            <a:chOff x="-123961" y="3881285"/>
            <a:chExt cx="612347" cy="213444"/>
          </a:xfrm>
        </p:grpSpPr>
        <p:sp>
          <p:nvSpPr>
            <p:cNvPr id="115" name="TextBox 114"/>
            <p:cNvSpPr txBox="1"/>
            <p:nvPr/>
          </p:nvSpPr>
          <p:spPr>
            <a:xfrm>
              <a:off x="-123961" y="3881285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1</a:t>
              </a:r>
              <a:r>
                <a:rPr lang="en-US" altLang="zh-CN" sz="700" b="1" dirty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rgbClr val="FF0000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-123961" y="3987007"/>
              <a:ext cx="612347" cy="107722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00" b="1" i="1" dirty="0" smtClean="0">
                  <a:solidFill>
                    <a:schemeClr val="tx2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s03g03450 .</a:t>
              </a:r>
              <a:r>
                <a:rPr lang="en-US" altLang="zh-CN" sz="700" b="1" i="1" dirty="0" smtClean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2</a:t>
              </a:r>
              <a:r>
                <a:rPr lang="en-US" altLang="zh-CN" sz="700" b="1" dirty="0">
                  <a:solidFill>
                    <a:schemeClr val="tx2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:</a:t>
              </a:r>
              <a:endParaRPr lang="zh-CN" altLang="en-US" sz="700" b="1" dirty="0">
                <a:solidFill>
                  <a:schemeClr val="tx2"/>
                </a:solidFill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</p:grpSp>
      <p:cxnSp>
        <p:nvCxnSpPr>
          <p:cNvPr id="117" name="直接连接符 116"/>
          <p:cNvCxnSpPr/>
          <p:nvPr/>
        </p:nvCxnSpPr>
        <p:spPr>
          <a:xfrm flipH="1">
            <a:off x="1069331" y="2637481"/>
            <a:ext cx="108000" cy="0"/>
          </a:xfrm>
          <a:prstGeom prst="line">
            <a:avLst/>
          </a:prstGeom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矩形 117"/>
          <p:cNvSpPr/>
          <p:nvPr/>
        </p:nvSpPr>
        <p:spPr>
          <a:xfrm>
            <a:off x="979251" y="322655"/>
            <a:ext cx="2604983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164465">
              <a:lnSpc>
                <a:spcPct val="280000"/>
              </a:lnSpc>
              <a:spcAft>
                <a:spcPts val="0"/>
              </a:spcAft>
            </a:pPr>
            <a:r>
              <a:rPr lang="en-US" sz="750" b="1" kern="1200" dirty="0">
                <a:solidFill>
                  <a:srgbClr val="FF0000"/>
                </a:solidFill>
                <a:effectLst/>
                <a:latin typeface="Courier New" panose="02070309020205020404"/>
                <a:cs typeface="宋体" panose="02010600030101010101" pitchFamily="2" charset="-122"/>
              </a:rPr>
              <a:t>GTTCTTGCTGGTCAAAGAGGTTCAATTGCTGATGCTCTCGTGCTGAATGCTGCAGCATCTCTTCTTGTCAGTGGTAAAGTAAATACTTTGCATGATGGTGTAGCGTTAGCACAGGAAACACAACGCTCCGGGGAGGCCATCAACACACTTGAATCCTGGATAAAGATTTCCAAT-------------------------------------------------------------------------------------------</a:t>
            </a:r>
            <a:r>
              <a:rPr lang="en-US" sz="750" b="1" kern="1200" dirty="0" err="1" smtClean="0">
                <a:solidFill>
                  <a:srgbClr val="FF0000"/>
                </a:solidFill>
                <a:effectLst/>
                <a:latin typeface="Courier New" panose="02070309020205020404"/>
                <a:cs typeface="宋体" panose="02010600030101010101" pitchFamily="2" charset="-122"/>
              </a:rPr>
              <a:t>AGTTGCTGA</a:t>
            </a:r>
            <a:r>
              <a:rPr lang="en-US" sz="750" b="1" dirty="0" err="1" smtClean="0">
                <a:latin typeface="Courier New" panose="02070309020205020404"/>
                <a:cs typeface="宋体" panose="02010600030101010101" pitchFamily="2" charset="-122"/>
              </a:rPr>
              <a:t>gactgatgttggtt</a:t>
            </a:r>
            <a:endParaRPr lang="zh-CN" sz="1200" dirty="0">
              <a:effectLst/>
              <a:latin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3179164" y="2409340"/>
            <a:ext cx="41710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00" b="1" dirty="0">
                <a:solidFill>
                  <a:srgbClr val="00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r>
              <a:rPr lang="en-US" altLang="zh-CN" sz="600" b="1" dirty="0">
                <a:solidFill>
                  <a:srgbClr val="FF0000"/>
                </a:solidFill>
                <a:latin typeface="Courier New" panose="02070309020205020404"/>
                <a:cs typeface="宋体" panose="02010600030101010101" pitchFamily="2" charset="-122"/>
              </a:rPr>
              <a:t>--- </a:t>
            </a:r>
            <a:endParaRPr lang="zh-CN" altLang="en-US" sz="600" b="1" dirty="0">
              <a:solidFill>
                <a:srgbClr val="FF0000"/>
              </a:solidFill>
            </a:endParaRPr>
          </a:p>
        </p:txBody>
      </p:sp>
      <p:sp>
        <p:nvSpPr>
          <p:cNvPr id="121" name="矩形 120"/>
          <p:cNvSpPr/>
          <p:nvPr/>
        </p:nvSpPr>
        <p:spPr>
          <a:xfrm>
            <a:off x="3179164" y="2503704"/>
            <a:ext cx="41710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00" b="1" dirty="0">
                <a:solidFill>
                  <a:srgbClr val="00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r>
              <a:rPr lang="en-US" altLang="zh-CN" sz="600" b="1" dirty="0">
                <a:solidFill>
                  <a:schemeClr val="accent1">
                    <a:lumMod val="75000"/>
                  </a:schemeClr>
                </a:solidFill>
                <a:latin typeface="Courier New" panose="02070309020205020404"/>
                <a:cs typeface="宋体" panose="02010600030101010101" pitchFamily="2" charset="-122"/>
              </a:rPr>
              <a:t>---</a:t>
            </a:r>
            <a:r>
              <a:rPr lang="en-US" altLang="zh-CN" sz="600" b="1" dirty="0">
                <a:solidFill>
                  <a:srgbClr val="FF0000"/>
                </a:solidFill>
                <a:latin typeface="Courier New" panose="02070309020205020404"/>
                <a:cs typeface="宋体" panose="02010600030101010101" pitchFamily="2" charset="-122"/>
              </a:rPr>
              <a:t> </a:t>
            </a:r>
            <a:endParaRPr lang="zh-CN" altLang="en-US" sz="600" b="1" dirty="0">
              <a:solidFill>
                <a:srgbClr val="FF0000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2068089" y="251520"/>
          <a:ext cx="2646363" cy="2717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48" name="Prism 8" r:id="rId1" imgW="5467350" imgH="5362575" progId="Prism8.Document">
                  <p:embed/>
                </p:oleObj>
              </mc:Choice>
              <mc:Fallback>
                <p:oleObj name="Prism 8" r:id="rId1" imgW="5467350" imgH="5362575" progId="Prism8.Document">
                  <p:embed/>
                  <p:pic>
                    <p:nvPicPr>
                      <p:cNvPr id="0" name="图片 2974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068089" y="251520"/>
                        <a:ext cx="2646363" cy="27178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470344" y="529681"/>
            <a:ext cx="742511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i="1" dirty="0">
                <a:latin typeface="Arial" panose="020B0604020202020204" pitchFamily="34" charset="0"/>
                <a:cs typeface="Arial" panose="020B0604020202020204" pitchFamily="34" charset="0"/>
              </a:rPr>
              <a:t>Os03g03450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62835" y="1799476"/>
            <a:ext cx="13305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162835" y="2136783"/>
            <a:ext cx="13305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47748" y="2465095"/>
            <a:ext cx="5290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1467177" y="1441140"/>
            <a:ext cx="1241045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expression level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 rot="18900000">
            <a:off x="2489083" y="2622760"/>
            <a:ext cx="150682" cy="115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 rot="18900000">
            <a:off x="2844837" y="2752219"/>
            <a:ext cx="485709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MM9-Ri-1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 rot="18900000">
            <a:off x="3117121" y="2768401"/>
            <a:ext cx="538609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MM9-Ri-34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 rot="18900000">
            <a:off x="2728991" y="2672067"/>
            <a:ext cx="234038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lmm9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8900000">
            <a:off x="3381538" y="2788492"/>
            <a:ext cx="602729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MM9-Com-7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 rot="18900000">
            <a:off x="3711473" y="2801526"/>
            <a:ext cx="655629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MM9-Com-27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868814" y="2158686"/>
            <a:ext cx="7373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190697" y="2242640"/>
            <a:ext cx="7373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513567" y="2196501"/>
            <a:ext cx="7373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850562" y="638477"/>
            <a:ext cx="7373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166402" y="1265864"/>
            <a:ext cx="7373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177426" y="1217497"/>
            <a:ext cx="10579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77426" y="839762"/>
            <a:ext cx="10579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77426" y="447216"/>
            <a:ext cx="10579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72770" y="3203848"/>
            <a:ext cx="582731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lative expression levels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03g03450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WT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m9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transgenic plants. Data were presented as means ± SD of three biological replicates. Signiﬁcant differences compared with WT (Student’s t test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) were shown as double stars (**); </a:t>
            </a:r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zh-CN" alt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47"/>
          <p:cNvSpPr txBox="1"/>
          <p:nvPr/>
        </p:nvSpPr>
        <p:spPr>
          <a:xfrm>
            <a:off x="733020" y="1647180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728212" y="338148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0" name="组合 49"/>
          <p:cNvGrpSpPr>
            <a:grpSpLocks noChangeAspect="1"/>
          </p:cNvGrpSpPr>
          <p:nvPr/>
        </p:nvGrpSpPr>
        <p:grpSpPr>
          <a:xfrm>
            <a:off x="1031682" y="3547135"/>
            <a:ext cx="5040000" cy="1222017"/>
            <a:chOff x="739322" y="3984903"/>
            <a:chExt cx="5549692" cy="1345599"/>
          </a:xfrm>
        </p:grpSpPr>
        <p:grpSp>
          <p:nvGrpSpPr>
            <p:cNvPr id="51" name="组合 50"/>
            <p:cNvGrpSpPr>
              <a:grpSpLocks noChangeAspect="1"/>
            </p:cNvGrpSpPr>
            <p:nvPr/>
          </p:nvGrpSpPr>
          <p:grpSpPr>
            <a:xfrm>
              <a:off x="760949" y="4668107"/>
              <a:ext cx="5528065" cy="287445"/>
              <a:chOff x="-4972050" y="3928119"/>
              <a:chExt cx="15020925" cy="781051"/>
            </a:xfrm>
          </p:grpSpPr>
          <p:pic>
            <p:nvPicPr>
              <p:cNvPr id="89" name="Picture 2" descr="D:\2024下\080810-1-23-27(30)-2.jpg"/>
              <p:cNvPicPr>
                <a:picLocks noChangeAspect="1" noChangeArrowheads="1"/>
              </p:cNvPicPr>
              <p:nvPr/>
            </p:nvPicPr>
            <p:blipFill rotWithShape="1">
              <a:blip r:embed="rId1" cstate="print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876800" y="3928120"/>
                <a:ext cx="5172075" cy="78105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0" name="Picture 3" descr="D:\2024下\080810-1-23-27(30)-1.jpg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4972050" y="3928119"/>
                <a:ext cx="9848850" cy="78105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52" name="TextBox 51"/>
            <p:cNvSpPr txBox="1"/>
            <p:nvPr/>
          </p:nvSpPr>
          <p:spPr>
            <a:xfrm>
              <a:off x="739322" y="5004048"/>
              <a:ext cx="150682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110734" y="5004048"/>
              <a:ext cx="150682" cy="11541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4" name="Picture 2" descr="F:\桌面文件\图片\20230731互补\MDJ003.jpg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3148" y="3991054"/>
              <a:ext cx="169996" cy="65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5" name="Picture 3" descr="F:\桌面文件\图片\20230731互补\MDJ004.jpg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09718" y="3984903"/>
              <a:ext cx="150778" cy="6552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6" name="Picture 2"/>
            <p:cNvPicPr>
              <a:picLocks noChangeAspect="1" noChangeArrowheads="1"/>
            </p:cNvPicPr>
            <p:nvPr/>
          </p:nvPicPr>
          <p:blipFill rotWithShape="1">
            <a:blip r:embed="rId9" cstate="print">
              <a:lum bright="-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360" b="46350"/>
            <a:stretch>
              <a:fillRect/>
            </a:stretch>
          </p:blipFill>
          <p:spPr bwMode="auto">
            <a:xfrm>
              <a:off x="933144" y="3991054"/>
              <a:ext cx="5148000" cy="6535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7" name="矩形 56"/>
            <p:cNvSpPr/>
            <p:nvPr/>
          </p:nvSpPr>
          <p:spPr>
            <a:xfrm>
              <a:off x="3057169" y="5215086"/>
              <a:ext cx="730970" cy="115416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pPr lvl="0" algn="ctr"/>
              <a:r>
                <a:rPr lang="en-US" altLang="zh-CN" sz="750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MM9-KO-T3-10</a:t>
              </a:r>
              <a:endParaRPr lang="en-US" altLang="zh-CN" sz="7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 Box 22"/>
            <p:cNvSpPr txBox="1">
              <a:spLocks noChangeAspect="1" noChangeArrowheads="1"/>
            </p:cNvSpPr>
            <p:nvPr/>
          </p:nvSpPr>
          <p:spPr bwMode="auto">
            <a:xfrm>
              <a:off x="980728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>
                  <a:cs typeface="Arial" panose="020B0604020202020204" pitchFamily="34" charset="0"/>
                </a:rPr>
                <a:t>1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59" name="Text Box 23"/>
            <p:cNvSpPr txBox="1">
              <a:spLocks noChangeAspect="1" noChangeArrowheads="1"/>
            </p:cNvSpPr>
            <p:nvPr/>
          </p:nvSpPr>
          <p:spPr bwMode="auto">
            <a:xfrm>
              <a:off x="1152285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>
                  <a:cs typeface="Arial" panose="020B0604020202020204" pitchFamily="34" charset="0"/>
                </a:rPr>
                <a:t>2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60" name="Text Box 24"/>
            <p:cNvSpPr txBox="1">
              <a:spLocks noChangeAspect="1" noChangeArrowheads="1"/>
            </p:cNvSpPr>
            <p:nvPr/>
          </p:nvSpPr>
          <p:spPr bwMode="auto">
            <a:xfrm>
              <a:off x="1323842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>
                  <a:cs typeface="Arial" panose="020B0604020202020204" pitchFamily="34" charset="0"/>
                </a:rPr>
                <a:t>3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61" name="Text Box 25"/>
            <p:cNvSpPr txBox="1">
              <a:spLocks noChangeAspect="1" noChangeArrowheads="1"/>
            </p:cNvSpPr>
            <p:nvPr/>
          </p:nvSpPr>
          <p:spPr bwMode="auto">
            <a:xfrm>
              <a:off x="1495399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4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2" name="Text Box 26"/>
            <p:cNvSpPr txBox="1">
              <a:spLocks noChangeAspect="1" noChangeArrowheads="1"/>
            </p:cNvSpPr>
            <p:nvPr/>
          </p:nvSpPr>
          <p:spPr bwMode="auto">
            <a:xfrm>
              <a:off x="1666956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5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3" name="Text Box 27"/>
            <p:cNvSpPr txBox="1">
              <a:spLocks noChangeAspect="1" noChangeArrowheads="1"/>
            </p:cNvSpPr>
            <p:nvPr/>
          </p:nvSpPr>
          <p:spPr bwMode="auto">
            <a:xfrm>
              <a:off x="1838513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6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4" name="Text Box 28"/>
            <p:cNvSpPr txBox="1">
              <a:spLocks noChangeAspect="1" noChangeArrowheads="1"/>
            </p:cNvSpPr>
            <p:nvPr/>
          </p:nvSpPr>
          <p:spPr bwMode="auto">
            <a:xfrm>
              <a:off x="2010070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7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5" name="Text Box 29"/>
            <p:cNvSpPr txBox="1">
              <a:spLocks noChangeAspect="1" noChangeArrowheads="1"/>
            </p:cNvSpPr>
            <p:nvPr/>
          </p:nvSpPr>
          <p:spPr bwMode="auto">
            <a:xfrm>
              <a:off x="2181627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8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6" name="Text Box 30"/>
            <p:cNvSpPr txBox="1">
              <a:spLocks noChangeAspect="1" noChangeArrowheads="1"/>
            </p:cNvSpPr>
            <p:nvPr/>
          </p:nvSpPr>
          <p:spPr bwMode="auto">
            <a:xfrm>
              <a:off x="2353187" y="5004048"/>
              <a:ext cx="52900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>
                  <a:cs typeface="Arial" panose="020B0604020202020204" pitchFamily="34" charset="0"/>
                </a:rPr>
                <a:t>9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67" name="Text Box 31"/>
            <p:cNvSpPr txBox="1">
              <a:spLocks noChangeAspect="1" noChangeArrowheads="1"/>
            </p:cNvSpPr>
            <p:nvPr/>
          </p:nvSpPr>
          <p:spPr bwMode="auto">
            <a:xfrm>
              <a:off x="2495054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0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8" name="Text Box 32"/>
            <p:cNvSpPr txBox="1">
              <a:spLocks noChangeAspect="1" noChangeArrowheads="1"/>
            </p:cNvSpPr>
            <p:nvPr/>
          </p:nvSpPr>
          <p:spPr bwMode="auto">
            <a:xfrm>
              <a:off x="2666908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1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69" name="Text Box 33"/>
            <p:cNvSpPr txBox="1">
              <a:spLocks noChangeAspect="1" noChangeArrowheads="1"/>
            </p:cNvSpPr>
            <p:nvPr/>
          </p:nvSpPr>
          <p:spPr bwMode="auto">
            <a:xfrm>
              <a:off x="2838762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2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0" name="Text Box 34"/>
            <p:cNvSpPr txBox="1">
              <a:spLocks noChangeAspect="1" noChangeArrowheads="1"/>
            </p:cNvSpPr>
            <p:nvPr/>
          </p:nvSpPr>
          <p:spPr bwMode="auto">
            <a:xfrm>
              <a:off x="3010616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3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1" name="Text Box 35"/>
            <p:cNvSpPr txBox="1">
              <a:spLocks noChangeAspect="1" noChangeArrowheads="1"/>
            </p:cNvSpPr>
            <p:nvPr/>
          </p:nvSpPr>
          <p:spPr bwMode="auto">
            <a:xfrm>
              <a:off x="3182470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4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2" name="Text Box 36"/>
            <p:cNvSpPr txBox="1">
              <a:spLocks noChangeAspect="1" noChangeArrowheads="1"/>
            </p:cNvSpPr>
            <p:nvPr/>
          </p:nvSpPr>
          <p:spPr bwMode="auto">
            <a:xfrm>
              <a:off x="3354324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>
                  <a:cs typeface="Arial" panose="020B0604020202020204" pitchFamily="34" charset="0"/>
                </a:rPr>
                <a:t>15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73" name="Text Box 37"/>
            <p:cNvSpPr txBox="1">
              <a:spLocks noChangeAspect="1" noChangeArrowheads="1"/>
            </p:cNvSpPr>
            <p:nvPr/>
          </p:nvSpPr>
          <p:spPr bwMode="auto">
            <a:xfrm>
              <a:off x="3526178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6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4" name="Text Box 38"/>
            <p:cNvSpPr txBox="1">
              <a:spLocks noChangeAspect="1" noChangeArrowheads="1"/>
            </p:cNvSpPr>
            <p:nvPr/>
          </p:nvSpPr>
          <p:spPr bwMode="auto">
            <a:xfrm>
              <a:off x="3698032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7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5" name="Text Box 39"/>
            <p:cNvSpPr txBox="1">
              <a:spLocks noChangeAspect="1" noChangeArrowheads="1"/>
            </p:cNvSpPr>
            <p:nvPr/>
          </p:nvSpPr>
          <p:spPr bwMode="auto">
            <a:xfrm>
              <a:off x="3869886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8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6" name="Text Box 40"/>
            <p:cNvSpPr txBox="1">
              <a:spLocks noChangeAspect="1" noChangeArrowheads="1"/>
            </p:cNvSpPr>
            <p:nvPr/>
          </p:nvSpPr>
          <p:spPr bwMode="auto">
            <a:xfrm>
              <a:off x="4041740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19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7" name="Text Box 41"/>
            <p:cNvSpPr txBox="1">
              <a:spLocks noChangeAspect="1" noChangeArrowheads="1"/>
            </p:cNvSpPr>
            <p:nvPr/>
          </p:nvSpPr>
          <p:spPr bwMode="auto">
            <a:xfrm>
              <a:off x="4213597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>
                  <a:cs typeface="Arial" panose="020B0604020202020204" pitchFamily="34" charset="0"/>
                </a:rPr>
                <a:t>20</a:t>
              </a:r>
              <a:endParaRPr lang="en-US" altLang="zh-CN" sz="750">
                <a:cs typeface="Arial" panose="020B0604020202020204" pitchFamily="34" charset="0"/>
              </a:endParaRPr>
            </a:p>
          </p:txBody>
        </p:sp>
        <p:sp>
          <p:nvSpPr>
            <p:cNvPr id="78" name="Text Box 32"/>
            <p:cNvSpPr txBox="1">
              <a:spLocks noChangeAspect="1" noChangeArrowheads="1"/>
            </p:cNvSpPr>
            <p:nvPr/>
          </p:nvSpPr>
          <p:spPr bwMode="auto">
            <a:xfrm>
              <a:off x="4412141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1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79" name="Text Box 33"/>
            <p:cNvSpPr txBox="1">
              <a:spLocks noChangeAspect="1" noChangeArrowheads="1"/>
            </p:cNvSpPr>
            <p:nvPr/>
          </p:nvSpPr>
          <p:spPr bwMode="auto">
            <a:xfrm>
              <a:off x="4583290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2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0" name="Text Box 34"/>
            <p:cNvSpPr txBox="1">
              <a:spLocks noChangeAspect="1" noChangeArrowheads="1"/>
            </p:cNvSpPr>
            <p:nvPr/>
          </p:nvSpPr>
          <p:spPr bwMode="auto">
            <a:xfrm>
              <a:off x="4754439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3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1" name="Text Box 35"/>
            <p:cNvSpPr txBox="1">
              <a:spLocks noChangeAspect="1" noChangeArrowheads="1"/>
            </p:cNvSpPr>
            <p:nvPr/>
          </p:nvSpPr>
          <p:spPr bwMode="auto">
            <a:xfrm>
              <a:off x="4925588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4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2" name="Text Box 36"/>
            <p:cNvSpPr txBox="1">
              <a:spLocks noChangeAspect="1" noChangeArrowheads="1"/>
            </p:cNvSpPr>
            <p:nvPr/>
          </p:nvSpPr>
          <p:spPr bwMode="auto">
            <a:xfrm>
              <a:off x="5096737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5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3" name="Text Box 37"/>
            <p:cNvSpPr txBox="1">
              <a:spLocks noChangeAspect="1" noChangeArrowheads="1"/>
            </p:cNvSpPr>
            <p:nvPr/>
          </p:nvSpPr>
          <p:spPr bwMode="auto">
            <a:xfrm>
              <a:off x="5267886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6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4" name="Text Box 38"/>
            <p:cNvSpPr txBox="1">
              <a:spLocks noChangeAspect="1" noChangeArrowheads="1"/>
            </p:cNvSpPr>
            <p:nvPr/>
          </p:nvSpPr>
          <p:spPr bwMode="auto">
            <a:xfrm>
              <a:off x="5439035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7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5" name="Text Box 39"/>
            <p:cNvSpPr txBox="1">
              <a:spLocks noChangeAspect="1" noChangeArrowheads="1"/>
            </p:cNvSpPr>
            <p:nvPr/>
          </p:nvSpPr>
          <p:spPr bwMode="auto">
            <a:xfrm>
              <a:off x="5610184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8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6" name="Text Box 40"/>
            <p:cNvSpPr txBox="1">
              <a:spLocks noChangeAspect="1" noChangeArrowheads="1"/>
            </p:cNvSpPr>
            <p:nvPr/>
          </p:nvSpPr>
          <p:spPr bwMode="auto">
            <a:xfrm>
              <a:off x="5781333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29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sp>
          <p:nvSpPr>
            <p:cNvPr id="87" name="Text Box 41"/>
            <p:cNvSpPr txBox="1">
              <a:spLocks noChangeAspect="1" noChangeArrowheads="1"/>
            </p:cNvSpPr>
            <p:nvPr/>
          </p:nvSpPr>
          <p:spPr bwMode="auto">
            <a:xfrm>
              <a:off x="5952480" y="5004048"/>
              <a:ext cx="105798" cy="115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en-US" altLang="zh-CN" sz="750" dirty="0" smtClean="0">
                  <a:cs typeface="Arial" panose="020B0604020202020204" pitchFamily="34" charset="0"/>
                </a:rPr>
                <a:t>30</a:t>
              </a:r>
              <a:endParaRPr lang="en-US" altLang="zh-CN" sz="750" dirty="0">
                <a:cs typeface="Arial" panose="020B0604020202020204" pitchFamily="34" charset="0"/>
              </a:endParaRPr>
            </a:p>
          </p:txBody>
        </p:sp>
        <p:cxnSp>
          <p:nvCxnSpPr>
            <p:cNvPr id="88" name="直接连接符 87"/>
            <p:cNvCxnSpPr/>
            <p:nvPr/>
          </p:nvCxnSpPr>
          <p:spPr>
            <a:xfrm>
              <a:off x="972362" y="5171380"/>
              <a:ext cx="511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2" name="Picture 4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93" b="1351"/>
          <a:stretch>
            <a:fillRect/>
          </a:stretch>
        </p:blipFill>
        <p:spPr bwMode="auto">
          <a:xfrm>
            <a:off x="2360816" y="2863239"/>
            <a:ext cx="2500346" cy="340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3" name="矩形 92"/>
          <p:cNvSpPr/>
          <p:nvPr/>
        </p:nvSpPr>
        <p:spPr>
          <a:xfrm>
            <a:off x="1688324" y="2212333"/>
            <a:ext cx="425890" cy="11030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lvl="0"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allele 1 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(0)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1691388" y="2850326"/>
            <a:ext cx="525470" cy="110302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pPr lvl="0" algn="r"/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allele 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2 (-15)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2376612" y="2067038"/>
            <a:ext cx="3681329" cy="1103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lvl="0" algn="dist"/>
            <a:r>
              <a:rPr lang="en-US" altLang="zh-CN" sz="750" dirty="0" smtClean="0">
                <a:solidFill>
                  <a:prstClr val="black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TGCTGCTGGAGGAGGAGAACGAGGCGCGCATCGCCGCCTTCCT</a:t>
            </a:r>
            <a:endParaRPr lang="en-US" altLang="zh-CN" sz="75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6" name="矩形 95"/>
          <p:cNvSpPr/>
          <p:nvPr/>
        </p:nvSpPr>
        <p:spPr>
          <a:xfrm>
            <a:off x="2376179" y="2705031"/>
            <a:ext cx="2477156" cy="1103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dist"/>
            <a:r>
              <a:rPr lang="en-US" altLang="zh-CN" sz="75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CTGCTGCTGGAGGAGGAGGCCGCCTTCCT</a:t>
            </a:r>
            <a:endParaRPr lang="en-US" altLang="zh-CN" sz="750" dirty="0">
              <a:solidFill>
                <a:prstClr val="black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97" name="组合 96"/>
          <p:cNvGrpSpPr/>
          <p:nvPr/>
        </p:nvGrpSpPr>
        <p:grpSpPr>
          <a:xfrm>
            <a:off x="2363934" y="2229005"/>
            <a:ext cx="3719837" cy="340525"/>
            <a:chOff x="2210651" y="1446834"/>
            <a:chExt cx="3892293" cy="356312"/>
          </a:xfrm>
        </p:grpSpPr>
        <p:pic>
          <p:nvPicPr>
            <p:cNvPr id="126" name="Picture 7"/>
            <p:cNvPicPr>
              <a:picLocks noChangeAspect="1" noChangeArrowheads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005" b="53701"/>
            <a:stretch>
              <a:fillRect/>
            </a:stretch>
          </p:blipFill>
          <p:spPr bwMode="auto">
            <a:xfrm>
              <a:off x="2210651" y="1446834"/>
              <a:ext cx="2356858" cy="35631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7" name="Picture 8"/>
            <p:cNvPicPr>
              <a:picLocks noChangeAspect="1" noChangeArrowheads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944" t="5121" r="2978" b="52622"/>
            <a:stretch>
              <a:fillRect/>
            </a:stretch>
          </p:blipFill>
          <p:spPr bwMode="auto">
            <a:xfrm>
              <a:off x="4534899" y="1446834"/>
              <a:ext cx="1568045" cy="3563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8" name="矩形 97"/>
          <p:cNvSpPr/>
          <p:nvPr/>
        </p:nvSpPr>
        <p:spPr>
          <a:xfrm>
            <a:off x="2620821" y="1834776"/>
            <a:ext cx="1774800" cy="110302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dist"/>
            <a:r>
              <a:rPr lang="en-US" altLang="zh-CN" sz="75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CTGCTGGAGGAGGAGAACGAG</a:t>
            </a:r>
            <a:endParaRPr lang="zh-CN" altLang="en-US" sz="750" dirty="0">
              <a:solidFill>
                <a:srgbClr val="0000FF"/>
              </a:solidFill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1609318" y="1849728"/>
            <a:ext cx="60753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 err="1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ispr</a:t>
            </a:r>
            <a:r>
              <a:rPr lang="en-US" altLang="zh-CN" sz="750" dirty="0" smtClean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arget 1</a:t>
            </a:r>
            <a:endParaRPr lang="zh-CN" altLang="en-US" sz="750" dirty="0">
              <a:solidFill>
                <a:srgbClr val="00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043771" y="2471730"/>
            <a:ext cx="428954" cy="22060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LMM9-KO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-T3-10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接箭头连接符 100"/>
          <p:cNvCxnSpPr/>
          <p:nvPr/>
        </p:nvCxnSpPr>
        <p:spPr>
          <a:xfrm>
            <a:off x="3958817" y="2638110"/>
            <a:ext cx="0" cy="103215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/>
          <p:cNvCxnSpPr/>
          <p:nvPr/>
        </p:nvCxnSpPr>
        <p:spPr>
          <a:xfrm>
            <a:off x="1635913" y="2255473"/>
            <a:ext cx="0" cy="71152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组合 33"/>
          <p:cNvGrpSpPr/>
          <p:nvPr/>
        </p:nvGrpSpPr>
        <p:grpSpPr>
          <a:xfrm>
            <a:off x="2663762" y="1968729"/>
            <a:ext cx="1719559" cy="103215"/>
            <a:chOff x="2663762" y="1927342"/>
            <a:chExt cx="1719559" cy="103215"/>
          </a:xfrm>
        </p:grpSpPr>
        <p:cxnSp>
          <p:nvCxnSpPr>
            <p:cNvPr id="104" name="直接连接符 103"/>
            <p:cNvCxnSpPr/>
            <p:nvPr/>
          </p:nvCxnSpPr>
          <p:spPr>
            <a:xfrm>
              <a:off x="2663762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接连接符 104"/>
            <p:cNvCxnSpPr/>
            <p:nvPr/>
          </p:nvCxnSpPr>
          <p:spPr>
            <a:xfrm>
              <a:off x="2827530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接连接符 105"/>
            <p:cNvCxnSpPr/>
            <p:nvPr/>
          </p:nvCxnSpPr>
          <p:spPr>
            <a:xfrm>
              <a:off x="2991298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接连接符 106"/>
            <p:cNvCxnSpPr/>
            <p:nvPr/>
          </p:nvCxnSpPr>
          <p:spPr>
            <a:xfrm>
              <a:off x="3073182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/>
            <p:cNvCxnSpPr/>
            <p:nvPr/>
          </p:nvCxnSpPr>
          <p:spPr>
            <a:xfrm>
              <a:off x="2745646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/>
            <p:cNvCxnSpPr/>
            <p:nvPr/>
          </p:nvCxnSpPr>
          <p:spPr>
            <a:xfrm>
              <a:off x="2909414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接连接符 109"/>
            <p:cNvCxnSpPr/>
            <p:nvPr/>
          </p:nvCxnSpPr>
          <p:spPr>
            <a:xfrm>
              <a:off x="3155066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接连接符 110"/>
            <p:cNvCxnSpPr/>
            <p:nvPr/>
          </p:nvCxnSpPr>
          <p:spPr>
            <a:xfrm>
              <a:off x="3318834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接连接符 111"/>
            <p:cNvCxnSpPr/>
            <p:nvPr/>
          </p:nvCxnSpPr>
          <p:spPr>
            <a:xfrm>
              <a:off x="3482602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接连接符 112"/>
            <p:cNvCxnSpPr/>
            <p:nvPr/>
          </p:nvCxnSpPr>
          <p:spPr>
            <a:xfrm>
              <a:off x="3564486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接连接符 113"/>
            <p:cNvCxnSpPr/>
            <p:nvPr/>
          </p:nvCxnSpPr>
          <p:spPr>
            <a:xfrm>
              <a:off x="3236950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接连接符 114"/>
            <p:cNvCxnSpPr/>
            <p:nvPr/>
          </p:nvCxnSpPr>
          <p:spPr>
            <a:xfrm>
              <a:off x="3400718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接连接符 115"/>
            <p:cNvCxnSpPr/>
            <p:nvPr/>
          </p:nvCxnSpPr>
          <p:spPr>
            <a:xfrm>
              <a:off x="3646370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接连接符 116"/>
            <p:cNvCxnSpPr/>
            <p:nvPr/>
          </p:nvCxnSpPr>
          <p:spPr>
            <a:xfrm>
              <a:off x="3810138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/>
            <p:cNvCxnSpPr/>
            <p:nvPr/>
          </p:nvCxnSpPr>
          <p:spPr>
            <a:xfrm>
              <a:off x="3973906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118"/>
            <p:cNvCxnSpPr/>
            <p:nvPr/>
          </p:nvCxnSpPr>
          <p:spPr>
            <a:xfrm>
              <a:off x="4055790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接连接符 119"/>
            <p:cNvCxnSpPr/>
            <p:nvPr/>
          </p:nvCxnSpPr>
          <p:spPr>
            <a:xfrm>
              <a:off x="3728254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接连接符 120"/>
            <p:cNvCxnSpPr/>
            <p:nvPr/>
          </p:nvCxnSpPr>
          <p:spPr>
            <a:xfrm>
              <a:off x="3892022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接连接符 121"/>
            <p:cNvCxnSpPr/>
            <p:nvPr/>
          </p:nvCxnSpPr>
          <p:spPr>
            <a:xfrm>
              <a:off x="4137674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接连接符 122"/>
            <p:cNvCxnSpPr/>
            <p:nvPr/>
          </p:nvCxnSpPr>
          <p:spPr>
            <a:xfrm>
              <a:off x="4301442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接连接符 123"/>
            <p:cNvCxnSpPr/>
            <p:nvPr/>
          </p:nvCxnSpPr>
          <p:spPr>
            <a:xfrm>
              <a:off x="4219558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接连接符 124"/>
            <p:cNvCxnSpPr/>
            <p:nvPr/>
          </p:nvCxnSpPr>
          <p:spPr>
            <a:xfrm>
              <a:off x="4383321" y="1927342"/>
              <a:ext cx="0" cy="103215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8" name="矩形 127"/>
          <p:cNvSpPr/>
          <p:nvPr/>
        </p:nvSpPr>
        <p:spPr>
          <a:xfrm>
            <a:off x="595791" y="5218331"/>
            <a:ext cx="583264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of LMM9-KO plants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diagram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RISPR/Cas9 target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d for LMM9-KO plants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ing results of LMM9-KO-T3-10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nt a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rispr target region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Red arrow indicates the 15-bp deletion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type and phenotype analysis of LMM9-KO-T3-10 offsprings.</a:t>
            </a:r>
            <a:endParaRPr lang="en-US" altLang="zh-CN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728212" y="49561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矩形 143"/>
          <p:cNvSpPr/>
          <p:nvPr/>
        </p:nvSpPr>
        <p:spPr>
          <a:xfrm>
            <a:off x="1067194" y="838398"/>
            <a:ext cx="758541" cy="20774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50" i="1" dirty="0" smtClean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Os03g03450</a:t>
            </a:r>
            <a:endParaRPr lang="zh-CN" altLang="en-US" sz="75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9" name="组合 148"/>
          <p:cNvGrpSpPr/>
          <p:nvPr/>
        </p:nvGrpSpPr>
        <p:grpSpPr>
          <a:xfrm>
            <a:off x="1595014" y="1253144"/>
            <a:ext cx="1499363" cy="181462"/>
            <a:chOff x="1993509" y="7000438"/>
            <a:chExt cx="1410725" cy="117001"/>
          </a:xfrm>
        </p:grpSpPr>
        <p:cxnSp>
          <p:nvCxnSpPr>
            <p:cNvPr id="187" name="直接连接符 186"/>
            <p:cNvCxnSpPr/>
            <p:nvPr/>
          </p:nvCxnSpPr>
          <p:spPr>
            <a:xfrm>
              <a:off x="2706572" y="7000438"/>
              <a:ext cx="697662" cy="1170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接连接符 187"/>
            <p:cNvCxnSpPr/>
            <p:nvPr/>
          </p:nvCxnSpPr>
          <p:spPr>
            <a:xfrm flipH="1">
              <a:off x="1993509" y="7000438"/>
              <a:ext cx="707502" cy="1170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1" name="矩形 150"/>
          <p:cNvSpPr/>
          <p:nvPr/>
        </p:nvSpPr>
        <p:spPr>
          <a:xfrm>
            <a:off x="1563659" y="1464811"/>
            <a:ext cx="2080698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TGCTGGAGGAGGAGAACGAGG (380</a:t>
            </a:r>
            <a:r>
              <a:rPr lang="en-US" altLang="zh-CN" sz="800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zh-CN" sz="750" dirty="0" smtClean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2)</a:t>
            </a:r>
            <a:endParaRPr lang="en-US" altLang="zh-CN" sz="750" dirty="0" smtClean="0">
              <a:solidFill>
                <a:srgbClr val="0000CC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直接连接符 156"/>
          <p:cNvCxnSpPr/>
          <p:nvPr/>
        </p:nvCxnSpPr>
        <p:spPr>
          <a:xfrm flipV="1">
            <a:off x="2491772" y="838398"/>
            <a:ext cx="1645902" cy="3144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接连接符 157"/>
          <p:cNvCxnSpPr/>
          <p:nvPr/>
        </p:nvCxnSpPr>
        <p:spPr>
          <a:xfrm flipV="1">
            <a:off x="2498521" y="838398"/>
            <a:ext cx="187916" cy="30984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矩形 160"/>
          <p:cNvSpPr/>
          <p:nvPr/>
        </p:nvSpPr>
        <p:spPr>
          <a:xfrm>
            <a:off x="2688957" y="691722"/>
            <a:ext cx="2002151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GGTTGGCGAAGGCGATGTAGG (553</a:t>
            </a:r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575)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矩形 163"/>
          <p:cNvSpPr/>
          <p:nvPr/>
        </p:nvSpPr>
        <p:spPr>
          <a:xfrm>
            <a:off x="1143896" y="1459332"/>
            <a:ext cx="357470" cy="115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Target 1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2218647" y="691722"/>
            <a:ext cx="357470" cy="115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Target 2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6" name="组合 165"/>
          <p:cNvGrpSpPr/>
          <p:nvPr/>
        </p:nvGrpSpPr>
        <p:grpSpPr>
          <a:xfrm>
            <a:off x="5610627" y="1347411"/>
            <a:ext cx="346193" cy="122668"/>
            <a:chOff x="5366459" y="1360240"/>
            <a:chExt cx="325727" cy="115416"/>
          </a:xfrm>
        </p:grpSpPr>
        <p:cxnSp>
          <p:nvCxnSpPr>
            <p:cNvPr id="185" name="直接连接符 184"/>
            <p:cNvCxnSpPr/>
            <p:nvPr/>
          </p:nvCxnSpPr>
          <p:spPr>
            <a:xfrm>
              <a:off x="5366459" y="1475656"/>
              <a:ext cx="325169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矩形 185"/>
            <p:cNvSpPr/>
            <p:nvPr/>
          </p:nvSpPr>
          <p:spPr>
            <a:xfrm>
              <a:off x="5400439" y="1360240"/>
              <a:ext cx="291747" cy="115416"/>
            </a:xfrm>
            <a:prstGeom prst="rect">
              <a:avLst/>
            </a:prstGeom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67" name="直接箭头连接符 166"/>
          <p:cNvCxnSpPr/>
          <p:nvPr/>
        </p:nvCxnSpPr>
        <p:spPr>
          <a:xfrm rot="16200000" flipH="1" flipV="1">
            <a:off x="1997819" y="1122236"/>
            <a:ext cx="61219" cy="0"/>
          </a:xfrm>
          <a:prstGeom prst="straightConnector1">
            <a:avLst/>
          </a:prstGeom>
          <a:ln w="6350">
            <a:solidFill>
              <a:schemeClr val="tx1"/>
            </a:solidFill>
            <a:headEnd type="none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矩形 167"/>
          <p:cNvSpPr/>
          <p:nvPr/>
        </p:nvSpPr>
        <p:spPr>
          <a:xfrm>
            <a:off x="1996035" y="968958"/>
            <a:ext cx="198772" cy="115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ATG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9" name="直接箭头连接符 168"/>
          <p:cNvCxnSpPr/>
          <p:nvPr/>
        </p:nvCxnSpPr>
        <p:spPr>
          <a:xfrm rot="16200000" flipH="1" flipV="1">
            <a:off x="5285338" y="1122236"/>
            <a:ext cx="61219" cy="0"/>
          </a:xfrm>
          <a:prstGeom prst="straightConnector1">
            <a:avLst/>
          </a:prstGeom>
          <a:ln w="6350">
            <a:solidFill>
              <a:schemeClr val="tx1"/>
            </a:solidFill>
            <a:headEnd type="none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矩形 169"/>
          <p:cNvSpPr/>
          <p:nvPr/>
        </p:nvSpPr>
        <p:spPr>
          <a:xfrm>
            <a:off x="5285236" y="968958"/>
            <a:ext cx="198772" cy="1154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TGA</a:t>
            </a:r>
            <a:endParaRPr lang="en-US" altLang="zh-CN" sz="75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1" name="组合 170"/>
          <p:cNvGrpSpPr>
            <a:grpSpLocks noChangeAspect="1"/>
          </p:cNvGrpSpPr>
          <p:nvPr/>
        </p:nvGrpSpPr>
        <p:grpSpPr>
          <a:xfrm>
            <a:off x="1701287" y="1156786"/>
            <a:ext cx="4320001" cy="97979"/>
            <a:chOff x="2293483" y="385997"/>
            <a:chExt cx="2456455" cy="55713"/>
          </a:xfrm>
        </p:grpSpPr>
        <p:cxnSp>
          <p:nvCxnSpPr>
            <p:cNvPr id="172" name="直接连接符 171"/>
            <p:cNvCxnSpPr/>
            <p:nvPr/>
          </p:nvCxnSpPr>
          <p:spPr>
            <a:xfrm>
              <a:off x="2293483" y="417649"/>
              <a:ext cx="245645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五边形 172"/>
            <p:cNvSpPr/>
            <p:nvPr/>
          </p:nvSpPr>
          <p:spPr>
            <a:xfrm>
              <a:off x="4348865" y="385997"/>
              <a:ext cx="373442" cy="54638"/>
            </a:xfrm>
            <a:prstGeom prst="homePlate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矩形 173"/>
            <p:cNvSpPr/>
            <p:nvPr/>
          </p:nvSpPr>
          <p:spPr>
            <a:xfrm>
              <a:off x="2631870" y="386285"/>
              <a:ext cx="59638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矩形 174"/>
            <p:cNvSpPr/>
            <p:nvPr/>
          </p:nvSpPr>
          <p:spPr>
            <a:xfrm>
              <a:off x="2734895" y="386285"/>
              <a:ext cx="69901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矩形 175"/>
            <p:cNvSpPr/>
            <p:nvPr/>
          </p:nvSpPr>
          <p:spPr>
            <a:xfrm>
              <a:off x="2872065" y="386285"/>
              <a:ext cx="36727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矩形 176"/>
            <p:cNvSpPr/>
            <p:nvPr/>
          </p:nvSpPr>
          <p:spPr>
            <a:xfrm>
              <a:off x="3811623" y="386285"/>
              <a:ext cx="40282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矩形 177"/>
            <p:cNvSpPr/>
            <p:nvPr/>
          </p:nvSpPr>
          <p:spPr>
            <a:xfrm>
              <a:off x="3517805" y="386285"/>
              <a:ext cx="82933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矩形 178"/>
            <p:cNvSpPr/>
            <p:nvPr/>
          </p:nvSpPr>
          <p:spPr>
            <a:xfrm>
              <a:off x="3919883" y="386285"/>
              <a:ext cx="26065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矩形 179"/>
            <p:cNvSpPr/>
            <p:nvPr/>
          </p:nvSpPr>
          <p:spPr>
            <a:xfrm>
              <a:off x="4045993" y="386285"/>
              <a:ext cx="52130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矩形 180"/>
            <p:cNvSpPr/>
            <p:nvPr/>
          </p:nvSpPr>
          <p:spPr>
            <a:xfrm>
              <a:off x="4346656" y="385997"/>
              <a:ext cx="4417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矩形 181"/>
            <p:cNvSpPr/>
            <p:nvPr/>
          </p:nvSpPr>
          <p:spPr>
            <a:xfrm>
              <a:off x="4249755" y="386285"/>
              <a:ext cx="58053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矩形 182"/>
            <p:cNvSpPr/>
            <p:nvPr/>
          </p:nvSpPr>
          <p:spPr>
            <a:xfrm>
              <a:off x="2483514" y="386285"/>
              <a:ext cx="90562" cy="5463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zh-CN" altLang="en-US" sz="600">
                <a:ln w="6350">
                  <a:solidFill>
                    <a:schemeClr val="tx1"/>
                  </a:solidFill>
                </a:ln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矩形 183"/>
            <p:cNvSpPr/>
            <p:nvPr/>
          </p:nvSpPr>
          <p:spPr>
            <a:xfrm>
              <a:off x="2433901" y="387026"/>
              <a:ext cx="46800" cy="54684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矩形 15"/>
          <p:cNvSpPr/>
          <p:nvPr/>
        </p:nvSpPr>
        <p:spPr>
          <a:xfrm>
            <a:off x="895006" y="5862325"/>
            <a:ext cx="534154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y of OsPAT1 homologs, which could be classed into four groups (I–IV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en-US" altLang="zh-CN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0"/>
          <p:cNvGrpSpPr>
            <a:grpSpLocks noChangeAspect="1"/>
          </p:cNvGrpSpPr>
          <p:nvPr/>
        </p:nvGrpSpPr>
        <p:grpSpPr>
          <a:xfrm>
            <a:off x="766373" y="539552"/>
            <a:ext cx="5478909" cy="5400000"/>
            <a:chOff x="764704" y="467544"/>
            <a:chExt cx="4748388" cy="4680000"/>
          </a:xfrm>
        </p:grpSpPr>
        <p:sp>
          <p:nvSpPr>
            <p:cNvPr id="17" name="矩形 16"/>
            <p:cNvSpPr/>
            <p:nvPr/>
          </p:nvSpPr>
          <p:spPr>
            <a:xfrm>
              <a:off x="3507892" y="2960508"/>
              <a:ext cx="2005200" cy="702000"/>
            </a:xfrm>
            <a:prstGeom prst="rect">
              <a:avLst/>
            </a:prstGeom>
            <a:solidFill>
              <a:srgbClr val="1EFA1E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3506793" y="3662508"/>
              <a:ext cx="2004654" cy="819694"/>
            </a:xfrm>
            <a:prstGeom prst="rect">
              <a:avLst/>
            </a:prstGeom>
            <a:solidFill>
              <a:srgbClr val="7030A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/>
            <p:cNvSpPr/>
            <p:nvPr/>
          </p:nvSpPr>
          <p:spPr>
            <a:xfrm>
              <a:off x="3502149" y="511027"/>
              <a:ext cx="2004654" cy="1359036"/>
            </a:xfrm>
            <a:prstGeom prst="rect">
              <a:avLst/>
            </a:prstGeom>
            <a:solidFill>
              <a:srgbClr val="FC64E6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3507892" y="1868807"/>
              <a:ext cx="2004652" cy="1091702"/>
            </a:xfrm>
            <a:prstGeom prst="rect">
              <a:avLst/>
            </a:prstGeom>
            <a:solidFill>
              <a:srgbClr val="FFC000">
                <a:alpha val="50196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椭圆 24"/>
            <p:cNvSpPr/>
            <p:nvPr/>
          </p:nvSpPr>
          <p:spPr>
            <a:xfrm>
              <a:off x="4481392" y="2408828"/>
              <a:ext cx="27728" cy="23625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椭圆 25"/>
            <p:cNvSpPr/>
            <p:nvPr/>
          </p:nvSpPr>
          <p:spPr>
            <a:xfrm>
              <a:off x="4481392" y="2499446"/>
              <a:ext cx="27728" cy="23625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white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椭圆 26"/>
            <p:cNvSpPr/>
            <p:nvPr/>
          </p:nvSpPr>
          <p:spPr>
            <a:xfrm>
              <a:off x="3933056" y="1506249"/>
              <a:ext cx="27728" cy="23625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11"/>
            <p:cNvSpPr txBox="1"/>
            <p:nvPr/>
          </p:nvSpPr>
          <p:spPr>
            <a:xfrm>
              <a:off x="5238012" y="1043512"/>
              <a:ext cx="3206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9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endParaRPr lang="zh-CN" alt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12"/>
            <p:cNvSpPr txBox="1"/>
            <p:nvPr/>
          </p:nvSpPr>
          <p:spPr>
            <a:xfrm>
              <a:off x="5221982" y="2345408"/>
              <a:ext cx="6412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9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endParaRPr lang="zh-CN" alt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13"/>
            <p:cNvSpPr txBox="1"/>
            <p:nvPr/>
          </p:nvSpPr>
          <p:spPr>
            <a:xfrm>
              <a:off x="5205952" y="3242258"/>
              <a:ext cx="96180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9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II</a:t>
              </a:r>
              <a:endParaRPr lang="zh-CN" alt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14"/>
            <p:cNvSpPr txBox="1"/>
            <p:nvPr/>
          </p:nvSpPr>
          <p:spPr>
            <a:xfrm>
              <a:off x="5199540" y="3971916"/>
              <a:ext cx="109004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9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V</a:t>
              </a:r>
              <a:endParaRPr lang="zh-CN" altLang="en-US" sz="9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" name="Picture 2" descr="C:\Users\rj\Desktop\发育树空2.tif"/>
            <p:cNvPicPr>
              <a:picLocks noChangeAspect="1" noChangeArrowheads="1"/>
            </p:cNvPicPr>
            <p:nvPr/>
          </p:nvPicPr>
          <p:blipFill>
            <a:blip r:embed="rId1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BEBA8EAE-BF5A-486C-A8C5-ECC9F3942E4B}">
                  <a14:imgProps xmlns:a14="http://schemas.microsoft.com/office/drawing/2010/main">
                    <a14:imgLayer r:embed="rId2">
                      <a14:imgEffect>
                        <a14:brightnessContrast contrast="10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704" y="467544"/>
              <a:ext cx="4447660" cy="468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表格 36"/>
          <p:cNvGraphicFramePr>
            <a:graphicFrameLocks noGrp="1"/>
          </p:cNvGraphicFramePr>
          <p:nvPr/>
        </p:nvGraphicFramePr>
        <p:xfrm>
          <a:off x="1456246" y="5988524"/>
          <a:ext cx="2250604" cy="914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250604"/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                                  440                                           460                                      </a:t>
                      </a:r>
                      <a:endParaRPr lang="zh-CN" sz="6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>
                    <a:noFill/>
                  </a:tcPr>
                </a:tc>
              </a:tr>
            </a:tbl>
          </a:graphicData>
        </a:graphic>
      </p:graphicFrame>
      <p:pic>
        <p:nvPicPr>
          <p:cNvPr id="55" name="Picture 11"/>
          <p:cNvPicPr>
            <a:picLocks noChangeAspect="1" noChangeArrowheads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8"/>
          <a:stretch>
            <a:fillRect/>
          </a:stretch>
        </p:blipFill>
        <p:spPr bwMode="auto">
          <a:xfrm>
            <a:off x="1507267" y="544004"/>
            <a:ext cx="4369718" cy="32251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Picture 10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98"/>
          <a:stretch>
            <a:fillRect/>
          </a:stretch>
        </p:blipFill>
        <p:spPr bwMode="auto">
          <a:xfrm>
            <a:off x="1507267" y="3762870"/>
            <a:ext cx="4369718" cy="32251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矩形 1"/>
          <p:cNvSpPr/>
          <p:nvPr/>
        </p:nvSpPr>
        <p:spPr>
          <a:xfrm>
            <a:off x="1143276" y="675862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1507267" y="675862"/>
            <a:ext cx="45980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AAS-----IKLSSSAKPLAPAPV----------------SHLLPLRAHHARPLPA--------------------RLPP : 4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AAS-----IKLSSSAKPLAPAPV----------------SHLLPLRAHHARPLPA--------------------RLPP : 4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TAS-----LKLCS-PKPLAPGAP----------------SPLLR-RPSTARPVAR--------------------RLPP : 38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AAS-----LKFAS-PKPLASAP-----------------SALLCGRRAQARPLPAS-------------------RLPP : 39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MVIAVATTSSIVSGIKLSGILTSFNAVDDASSSCGRSNLTGVRIFPTLSRRRFSSIGAVSPIRGDAQSSFSRSSFACSQNLGLSG : 85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VPTSIVSGIKLSGIVTSFNTPADVSSP-GR---ISVKVYPALPRRRFSSIGAVSSIRGDS----SRISFAYRQNLGLSG : 7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MAAALASQRTWLPSSSVGPFRGSFAT--------------APASSPRVLGVPRKFAVE-------------------SGKW : 48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--------------------------------------------------------------------------------- : -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--------------------------------------------------------------------------------- : -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507266" y="2818193"/>
            <a:ext cx="459807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CCV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G-LD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ST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E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 : 207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CV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G-LD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T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E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07</a:t>
            </a:r>
            <a:endParaRPr lang="zh-CN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NC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G-LH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T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E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04</a:t>
            </a:r>
            <a:endParaRPr lang="zh-CN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CCI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G-LD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T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E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03</a:t>
            </a:r>
            <a:endParaRPr lang="zh-CN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HAR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G-LV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S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52</a:t>
            </a:r>
            <a:endParaRPr lang="zh-CN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HAR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G-LA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S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E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40</a:t>
            </a:r>
            <a:endParaRPr lang="zh-CN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RAIP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T-VPG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SC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PE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D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215</a:t>
            </a:r>
            <a:endParaRPr lang="en-US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ACN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LGDMK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ST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PS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S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 : 155</a:t>
            </a:r>
            <a:endParaRPr lang="en-US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: KAIP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T-DGL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D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TGGD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H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IST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AK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S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GSADVLE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E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Q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CL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E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</a:t>
            </a:r>
            <a:r>
              <a:rPr lang="en-US" altLang="zh-CN" sz="600" b="1" dirty="0">
                <a:solidFill>
                  <a:schemeClr val="dk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 : 147</a:t>
            </a:r>
            <a:endParaRPr lang="en-US" altLang="zh-CN" sz="600" b="1" dirty="0">
              <a:solidFill>
                <a:schemeClr val="dk1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507266" y="1749706"/>
            <a:ext cx="45980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PPRVAVQHTAARASDASPRTASFDK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G-DHFSEEEAEATLR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-EENEARI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Y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K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G : 12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PPRVAVQHTAARASDASPRTASFDK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G-DHFSEEEAEATLR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-EENEARI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Y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K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G : 12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ARVAVQPAAAPAPAASPGTATFEQ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G-ADFTEDEAEATLQ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-EKNEARIA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Y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K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R : 12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PTRVAVQPPAAP---VATRIGSFDK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G-TDFSEEDAEATLK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-EKDEARIS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F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K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S : 119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FSAAEALPPACANASPSSIKSFNQ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R-VDLSETEAESSLE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-EANEALIS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Y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K : 168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LGAPEALPSVRENASASSIKSFNQ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R-VDLSESEAESSLE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-DTNEALIS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Y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K : 156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EVLVRNVRAQSSTVTVPARTLSIPQ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G-TNLTQAQTEEVME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-DANPAIIG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AS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S : 131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defRPr/>
            </a:pP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----------MSSAKSASLKP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GKRHLSVEETKEAFS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-GADEVQVG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P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VE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D : 7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defRPr/>
            </a:pP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---------------------MIKE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G-RSLATDEAAKVME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GEATPAQFG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GE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V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E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SR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A : 6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500931" y="3896155"/>
            <a:ext cx="459807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SAN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K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PY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E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AQK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K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 : 29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SAN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K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PY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E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AQK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K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 : 29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SAN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R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PY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E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AQK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Q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 : 287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SAN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R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PH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E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AQK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K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 : 286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SPM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G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SY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V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K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LQR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K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C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M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 : 335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APM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VS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VLGP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RVSY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V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K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M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ALQL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MK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-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M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 : 32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APT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VA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SRAPH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HD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ILQH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TKR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-H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M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 : 298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APV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VAP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R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SAQR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G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HP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ALKK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VDH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II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-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 : 239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M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APV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H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M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AAAP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R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FNILGP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PAGAKA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L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GDE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VLQG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CQH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LVH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DEIT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 : 231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1500931" y="4967494"/>
            <a:ext cx="45535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RKIEKML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P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VLQDVL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QRGSIA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SLLVSGKVN : 36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RKIEKML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P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VLQDVL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QRGSIA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SLLVSGKVN : 36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GKIEKML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P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VLQDVL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QRGSIA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SLLVSGKVK : 360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EKIEKMF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PA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VLQDVL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QRGAIAD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V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SLLVSGKVK : 359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EKIEEFS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PD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VLRRVL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ESGAIAD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ALLVSNRVQ : 408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Y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PEKIEEFS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R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PDY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VLRRVL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EKGSIAD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ALLVSNRVQ : 396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G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----------QDKIESFV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TL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AD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SLRNVF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EPGPIAD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I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GIMACGLVK : 371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A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NIAADGVLPKVYETKTFEF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I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ELI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PK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KFVDVL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DHTDAKRD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VL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VGCWIYGLSN : 324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H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----------NDHIERYIV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P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D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LPR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SSG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KG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VK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LLRNTI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--TLGSQRD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LMN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ALVAGDKVE : 304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500931" y="6034244"/>
            <a:ext cx="254189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TQ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N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SC--------- : 395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TQ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N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VSTSDN----- : 399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TQ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N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SC--------- : 392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TQ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N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SSRD------- : 393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EVQS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I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LAQKSQ----- : 444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EVHS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IK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S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H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LAQKSQ----- : 432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GE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DVLR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NT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N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KLKAEEVSE-- : 410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defRPr/>
            </a:pP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D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C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TTLE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D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KW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TV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EIASKELNKPE : 365</a:t>
            </a:r>
            <a:endParaRPr lang="zh-CN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pPr>
              <a:defRPr/>
            </a:pP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: T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QQ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VA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M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KEVIDN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AAK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L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DQL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I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EF</a:t>
            </a:r>
            <a:r>
              <a:rPr lang="en-US" altLang="zh-CN" sz="600" b="1" dirty="0">
                <a:solidFill>
                  <a:schemeClr val="bg1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S</a:t>
            </a:r>
            <a:r>
              <a:rPr lang="en-US" altLang="zh-CN" sz="600" b="1" dirty="0">
                <a:latin typeface="Courier New" panose="02070309020205020404" pitchFamily="49" charset="0"/>
                <a:cs typeface="Courier New" panose="02070309020205020404" pitchFamily="49" charset="0"/>
              </a:rPr>
              <a:t>RSLG-------- : 337</a:t>
            </a:r>
            <a:endParaRPr lang="en-US" altLang="zh-CN" sz="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2426241" y="2851986"/>
            <a:ext cx="234000" cy="846217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3717032" y="2854931"/>
            <a:ext cx="180000" cy="838510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  <p:sp>
        <p:nvSpPr>
          <p:cNvPr id="69" name="矩形 68"/>
          <p:cNvSpPr/>
          <p:nvPr/>
        </p:nvSpPr>
        <p:spPr>
          <a:xfrm>
            <a:off x="1052736" y="7134671"/>
            <a:ext cx="532859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ignment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OsPAT1 and some of its homolog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orted conserved motifs were indicated with red boxes. 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矩形 71"/>
          <p:cNvSpPr/>
          <p:nvPr/>
        </p:nvSpPr>
        <p:spPr>
          <a:xfrm>
            <a:off x="1143275" y="1749706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矩形 72"/>
          <p:cNvSpPr/>
          <p:nvPr/>
        </p:nvSpPr>
        <p:spPr>
          <a:xfrm>
            <a:off x="1143274" y="2821714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矩形 73"/>
          <p:cNvSpPr/>
          <p:nvPr/>
        </p:nvSpPr>
        <p:spPr>
          <a:xfrm>
            <a:off x="1143273" y="3893056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矩形 74"/>
          <p:cNvSpPr/>
          <p:nvPr/>
        </p:nvSpPr>
        <p:spPr>
          <a:xfrm>
            <a:off x="1126153" y="4961166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矩形 75"/>
          <p:cNvSpPr/>
          <p:nvPr/>
        </p:nvSpPr>
        <p:spPr>
          <a:xfrm>
            <a:off x="1138491" y="6025797"/>
            <a:ext cx="55752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endParaRPr lang="en-US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ZM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PAT1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nAnPRT</a:t>
            </a:r>
            <a:endParaRPr lang="zh-CN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p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cAnPRT</a:t>
            </a:r>
            <a:endParaRPr lang="en-US" altLang="zh-CN" sz="6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bAnPRT</a:t>
            </a:r>
            <a:endParaRPr lang="zh-CN" altLang="zh-CN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2882571" y="2852851"/>
            <a:ext cx="180000" cy="838510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7" name="Picture 3" descr="D:\0-研究生的工作\博士生-任俊\结构预测\TRP4.png"/>
          <p:cNvPicPr>
            <a:picLocks noChangeAspect="1" noChangeArrowheads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03" t="26162" r="41675" b="28515"/>
          <a:stretch>
            <a:fillRect/>
          </a:stretch>
        </p:blipFill>
        <p:spPr bwMode="auto">
          <a:xfrm>
            <a:off x="3814142" y="3223092"/>
            <a:ext cx="1447236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508" name="Picture 4" descr="D:\0-研究生的工作\博士生-任俊\结构预测\PAT.pn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48" t="23389" r="30358" b="26505"/>
          <a:stretch>
            <a:fillRect/>
          </a:stretch>
        </p:blipFill>
        <p:spPr bwMode="auto">
          <a:xfrm>
            <a:off x="862135" y="3264959"/>
            <a:ext cx="2460248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509" name="Picture 5" descr="D:\0-研究生的工作\博士生-任俊\结构预测\3450.1.pn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31" t="25798" r="39055" b="28651"/>
          <a:stretch>
            <a:fillRect/>
          </a:stretch>
        </p:blipFill>
        <p:spPr bwMode="auto">
          <a:xfrm>
            <a:off x="3583760" y="855812"/>
            <a:ext cx="1908000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510" name="Picture 6" descr="D:\0-研究生的工作\博士生-任俊\结构预测\TRP4&amp;PAT1-3450.1-全长白背景-2.pn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082" t="23345" r="30424" b="26999"/>
          <a:stretch>
            <a:fillRect/>
          </a:stretch>
        </p:blipFill>
        <p:spPr bwMode="auto">
          <a:xfrm>
            <a:off x="851000" y="855812"/>
            <a:ext cx="2482518" cy="180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356992" y="68356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9951" y="68356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09951" y="2987824"/>
            <a:ext cx="25519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356992" y="2987824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692696" y="5508103"/>
            <a:ext cx="525658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8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comparison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T1, OsPAT1.1, and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st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P4.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comparison of PAT1 (Blue), OsPAT1.1 (Green), and TRP4 (Magenta)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structure of OsPAT1.1 (by AlphaFold 3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dicted structure of PAT1 (by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phaFol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)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ucture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RP4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rom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DB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Box 130"/>
          <p:cNvSpPr txBox="1"/>
          <p:nvPr/>
        </p:nvSpPr>
        <p:spPr>
          <a:xfrm>
            <a:off x="548680" y="1763688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48680" y="233445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692696" y="7236296"/>
            <a:ext cx="551328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9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cellula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lization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AT1 domains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gram of the tested domains of OsPAT1.1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sPAT1.2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ellular localization of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domains of OsPAT1.1 and OsPAT1.2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rice protoplast. AOX-mcherry was used as the maker for mitochondria localization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Bars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20 µm. </a:t>
            </a:r>
            <a:endParaRPr lang="zh-CN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013529" y="4994050"/>
            <a:ext cx="705321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-N-GFP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3" name="Picture 2" descr="D:\20220514RJ\C66X1-2\C66X1-2_h0t0z0c3x0-1024y0-1024.jpg"/>
          <p:cNvPicPr>
            <a:picLocks noChangeAspect="1" noChangeArrowheads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811" y="5492873"/>
            <a:ext cx="825369" cy="7042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4" name="Picture 3" descr="D:\20220514RJ\C66X1-2\C66X1-2_h0t0z0c0-4x0-1024y0-1024.jp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7897" y="5492873"/>
            <a:ext cx="825369" cy="7042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5" name="Picture 4" descr="D:\20220514RJ\C66X1-2\C66X1-2_h0t0z0c0x0-1024y0-1024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4874" y="5492873"/>
            <a:ext cx="825369" cy="7107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6" name="Picture 5" descr="D:\20220514RJ\C66X1-2\C66X1-2_h0t0z0c1x0-1024y0-1024.jp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1853" y="5492873"/>
            <a:ext cx="825369" cy="7062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7" name="Picture 6" descr="D:\20220514RJ\C66X1-2\C66X1-2_h0t0z0c2x0-1024y0-1024.jpg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-1116"/>
          <a:stretch>
            <a:fillRect/>
          </a:stretch>
        </p:blipFill>
        <p:spPr bwMode="auto">
          <a:xfrm>
            <a:off x="2648832" y="5495253"/>
            <a:ext cx="825369" cy="7107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8" name="TextBox 137"/>
          <p:cNvSpPr txBox="1"/>
          <p:nvPr/>
        </p:nvSpPr>
        <p:spPr>
          <a:xfrm>
            <a:off x="827580" y="5772351"/>
            <a:ext cx="89127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FP-OsPAT1.1-C65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连接符 143"/>
          <p:cNvCxnSpPr/>
          <p:nvPr/>
        </p:nvCxnSpPr>
        <p:spPr>
          <a:xfrm rot="10800000">
            <a:off x="5557348" y="6152184"/>
            <a:ext cx="44024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5" name="Picture 7" descr="C:\Users\rj\Desktop\20220514RJ\C66X2-2\C66X2-2_h0t0z0c0-4x0-1024y0-1024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3134" y="6230499"/>
            <a:ext cx="825369" cy="76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6" name="Picture 8" descr="C:\Users\rj\Desktop\20220514RJ\C66X2-2\C66X2-2_h0t0z0c0x0-1024y0-1024.jpg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0985" y="6230499"/>
            <a:ext cx="825369" cy="76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7" name="Picture 9" descr="C:\Users\rj\Desktop\20220514RJ\C66X2-2\C66X2-2_h0t0z0c1x0-1024y0-1024.jpg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98837" y="6230499"/>
            <a:ext cx="825369" cy="76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8" name="Picture 10" descr="C:\Users\rj\Desktop\20220514RJ\C66X2-2\C66X2-2_h0t0z0c2x0-1024y0-1024.jpg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6689" y="6230499"/>
            <a:ext cx="825369" cy="76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9" name="Picture 11" descr="C:\Users\rj\Desktop\20220514RJ\C66X2-2\C66X2-2_h0t0z0c3x0-1024y0-1024.jpg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4541" y="6230499"/>
            <a:ext cx="825369" cy="7645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51" name="直接连接符 150"/>
          <p:cNvCxnSpPr/>
          <p:nvPr/>
        </p:nvCxnSpPr>
        <p:spPr>
          <a:xfrm rot="10800000">
            <a:off x="5557348" y="6942264"/>
            <a:ext cx="440246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TextBox 170"/>
          <p:cNvSpPr txBox="1"/>
          <p:nvPr/>
        </p:nvSpPr>
        <p:spPr>
          <a:xfrm>
            <a:off x="827580" y="6590639"/>
            <a:ext cx="89127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FP-OsPAT1.2-C65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964895" y="2009027"/>
            <a:ext cx="19877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093809" y="2009027"/>
            <a:ext cx="250068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5471319" y="2009027"/>
            <a:ext cx="323807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4521027" y="2009027"/>
            <a:ext cx="482504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hloroplast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矩形 125"/>
          <p:cNvSpPr/>
          <p:nvPr/>
        </p:nvSpPr>
        <p:spPr>
          <a:xfrm>
            <a:off x="3623418" y="2009027"/>
            <a:ext cx="599523" cy="115416"/>
          </a:xfrm>
          <a:prstGeom prst="rect">
            <a:avLst/>
          </a:prstGeom>
        </p:spPr>
        <p:txBody>
          <a:bodyPr wrap="none" lIns="0" tIns="0" rIns="0" bIns="0">
            <a:spAutoFit/>
          </a:bodyPr>
          <a:lstStyle/>
          <a:p>
            <a:r>
              <a:rPr lang="en-US" altLang="zh-CN" sz="750" dirty="0">
                <a:latin typeface="Arial" panose="020B0604020202020204" pitchFamily="34" charset="0"/>
                <a:cs typeface="Arial" panose="020B0604020202020204" pitchFamily="34" charset="0"/>
              </a:rPr>
              <a:t>AOX-mcherry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0" name="Picture 11" descr="D:\PAN580-H-Q+2aa-1\PAN580-H-Q+2aa-1_h0t0z0c0-4x0-1024y0-1024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0928" y="2185263"/>
            <a:ext cx="825924" cy="796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4" name="Picture 12" descr="D:\PAN580-H-Q+2aa-1\PAN580-H-Q+2aa-1_h0t0z0c0x0-1024y0-1024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8679" y="2185263"/>
            <a:ext cx="825924" cy="796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5" name="Picture 13" descr="D:\PAN580-H-Q+2aa-1\PAN580-H-Q+2aa-1_h0t0z0c1x0-1024y0-1024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6430" y="2185263"/>
            <a:ext cx="825924" cy="796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6" name="Picture 14" descr="D:\PAN580-H-Q+2aa-1\PAN580-H-Q+2aa-1_h0t0z0c2x0-1024y0-1024.jpg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4184" y="2185263"/>
            <a:ext cx="825924" cy="796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7" name="Picture 15" descr="D:\PAN580-H-Q+2aa-1\PAN580-H-Q+2aa-1_h0t0z0c3x0-1024y0-1024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6433" y="2185263"/>
            <a:ext cx="825924" cy="796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78" name="直接连接符 177"/>
          <p:cNvCxnSpPr/>
          <p:nvPr/>
        </p:nvCxnSpPr>
        <p:spPr>
          <a:xfrm>
            <a:off x="5402332" y="2874459"/>
            <a:ext cx="5424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/>
          <p:cNvSpPr txBox="1"/>
          <p:nvPr/>
        </p:nvSpPr>
        <p:spPr>
          <a:xfrm>
            <a:off x="1566647" y="2544939"/>
            <a:ext cx="19877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Picture 2" descr="D:\20241018\PAN580-ZH-x2-1\PAN580-ZH-x2-1_h0t0z0c0-4x0-1024y0-1024.jpg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2452" y="3017896"/>
            <a:ext cx="824400" cy="840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1" name="Picture 3" descr="D:\20241018\PAN580-ZH-x2-1\PAN580-ZH-x2-1_h0t0z0c0x0-1024y0-1024.jpg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1501" y="3017896"/>
            <a:ext cx="824400" cy="840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2" name="Picture 4" descr="D:\20241018\PAN580-ZH-x2-1\PAN580-ZH-x2-1_h0t0z0c1x0-1024y0-1024.jpg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0550" y="3017896"/>
            <a:ext cx="824400" cy="840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5" name="Picture 5" descr="D:\20241018\PAN580-ZH-x2-1\PAN580-ZH-x2-1_h0t0z0c2x0-1024y0-1024.jpg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9599" y="3017896"/>
            <a:ext cx="824400" cy="8402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6" name="Picture 6" descr="D:\20241018\PAN580-ZH-x2-1\PAN580-ZH-x2-1_h0t0z0c3x0-1024y0-1024.jpg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2298" y="3017896"/>
            <a:ext cx="824400" cy="840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87" name="直接连接符 86"/>
          <p:cNvCxnSpPr/>
          <p:nvPr/>
        </p:nvCxnSpPr>
        <p:spPr>
          <a:xfrm>
            <a:off x="5476732" y="3757052"/>
            <a:ext cx="46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1062943" y="3361340"/>
            <a:ext cx="68448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1-GFP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8" name="Picture 2" descr="D:\20241101rj\PTM-10\PTM-10_h0t0z0c0-4x0-1024y0-1024.jpg"/>
          <p:cNvPicPr>
            <a:picLocks noChangeAspect="1" noChangeArrowheads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5" b="-1"/>
          <a:stretch>
            <a:fillRect/>
          </a:stretch>
        </p:blipFill>
        <p:spPr bwMode="auto">
          <a:xfrm>
            <a:off x="5209156" y="4669408"/>
            <a:ext cx="824400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2" name="Picture 3" descr="D:\20241101rj\PTM-10\PTM-10_h0t0z0c0x0-1024y0-1024.jpg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5" b="-1"/>
          <a:stretch>
            <a:fillRect/>
          </a:stretch>
        </p:blipFill>
        <p:spPr bwMode="auto">
          <a:xfrm>
            <a:off x="4357228" y="4669408"/>
            <a:ext cx="824400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3" name="Picture 4" descr="D:\20241101rj\PTM-10\PTM-10_h0t0z0c1x0-1024y0-1024.jpg"/>
          <p:cNvPicPr>
            <a:picLocks noChangeAspect="1" noChangeArrowheads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5" b="-1"/>
          <a:stretch>
            <a:fillRect/>
          </a:stretch>
        </p:blipFill>
        <p:spPr bwMode="auto">
          <a:xfrm>
            <a:off x="3505299" y="4669408"/>
            <a:ext cx="824400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4" name="Picture 5" descr="D:\20241101rj\PTM-10\PTM-10_h0t0z0c2x0-1024y0-1024.jpg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5" b="-1"/>
          <a:stretch>
            <a:fillRect/>
          </a:stretch>
        </p:blipFill>
        <p:spPr bwMode="auto">
          <a:xfrm>
            <a:off x="2653370" y="4669408"/>
            <a:ext cx="824400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5" name="Picture 6" descr="D:\20241101rj\PTM-10\PTM-10_h0t0z0c3x0-1024y0-1024.jpg"/>
          <p:cNvPicPr>
            <a:picLocks noChangeAspect="1" noChangeArrowheads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605" b="-1"/>
          <a:stretch>
            <a:fillRect/>
          </a:stretch>
        </p:blipFill>
        <p:spPr bwMode="auto">
          <a:xfrm>
            <a:off x="1801441" y="4669408"/>
            <a:ext cx="824400" cy="792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97" name="直接连接符 96"/>
          <p:cNvCxnSpPr/>
          <p:nvPr/>
        </p:nvCxnSpPr>
        <p:spPr>
          <a:xfrm>
            <a:off x="5338885" y="5373815"/>
            <a:ext cx="605613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8" name="Picture 7" descr="D:\20241101rj\ZQ-X1-3\ZQ-X1-3_h0t0z0c0-4x0-1024y0-1024.jpg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11475" y="3900705"/>
            <a:ext cx="824400" cy="729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0" name="Picture 8" descr="D:\20241101rj\ZQ-X1-3\ZQ-X1-3_h0t0z0c0x0-1024y0-1024.jpg"/>
          <p:cNvPicPr>
            <a:picLocks noChangeAspect="1" noChangeArrowheads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9180" y="3900705"/>
            <a:ext cx="824400" cy="7299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" name="Picture 9" descr="D:\20241101rj\ZQ-X1-3\ZQ-X1-3_h0t0z0c1x0-1024y0-1024.jpg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6886" y="3900705"/>
            <a:ext cx="824400" cy="729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" name="Picture 10" descr="D:\20241101rj\ZQ-X1-3\ZQ-X1-3_h0t0z0c2x0-1024y0-1024.jpg"/>
          <p:cNvPicPr>
            <a:picLocks noChangeAspect="1" noChangeArrowheads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4592" y="3900705"/>
            <a:ext cx="824400" cy="7299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" name="Picture 11" descr="D:\20241101rj\ZQ-X1-3\ZQ-X1-3_h0t0z0c3x0-1024y0-1024.jpg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2298" y="3900705"/>
            <a:ext cx="824400" cy="7299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09" name="直接连接符 108"/>
          <p:cNvCxnSpPr/>
          <p:nvPr/>
        </p:nvCxnSpPr>
        <p:spPr>
          <a:xfrm>
            <a:off x="5290613" y="4498874"/>
            <a:ext cx="730335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1072468" y="4177741"/>
            <a:ext cx="684482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2-GFP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902949" y="1169384"/>
            <a:ext cx="1171796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1-C65 (65-395 </a:t>
            </a:r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02949" y="946704"/>
            <a:ext cx="90730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-N (1-50 </a:t>
            </a:r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902948" y="501345"/>
            <a:ext cx="939360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1</a:t>
            </a:r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(1-395 </a:t>
            </a:r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902948" y="724024"/>
            <a:ext cx="912109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2</a:t>
            </a:r>
            <a:r>
              <a:rPr lang="en-US" altLang="zh-CN" sz="75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(1-399 </a:t>
            </a:r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902949" y="1392063"/>
            <a:ext cx="1171796" cy="115416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OsPAT1.2-C65 (65-399 </a:t>
            </a:r>
            <a:r>
              <a:rPr lang="en-US" altLang="zh-CN" sz="75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  <a:r>
              <a:rPr lang="en-US" altLang="zh-CN" sz="75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7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组合 8"/>
          <p:cNvGrpSpPr>
            <a:grpSpLocks noChangeAspect="1"/>
          </p:cNvGrpSpPr>
          <p:nvPr/>
        </p:nvGrpSpPr>
        <p:grpSpPr>
          <a:xfrm>
            <a:off x="2219395" y="530376"/>
            <a:ext cx="3780000" cy="940050"/>
            <a:chOff x="2140132" y="488388"/>
            <a:chExt cx="4097180" cy="1018929"/>
          </a:xfrm>
        </p:grpSpPr>
        <p:grpSp>
          <p:nvGrpSpPr>
            <p:cNvPr id="29" name="组合 28"/>
            <p:cNvGrpSpPr/>
            <p:nvPr/>
          </p:nvGrpSpPr>
          <p:grpSpPr>
            <a:xfrm>
              <a:off x="5267137" y="570294"/>
              <a:ext cx="970175" cy="492848"/>
              <a:chOff x="5312394" y="763467"/>
              <a:chExt cx="1041788" cy="529228"/>
            </a:xfrm>
          </p:grpSpPr>
          <p:sp>
            <p:nvSpPr>
              <p:cNvPr id="150" name="矩形 149"/>
              <p:cNvSpPr/>
              <p:nvPr/>
            </p:nvSpPr>
            <p:spPr>
              <a:xfrm>
                <a:off x="5622749" y="852598"/>
                <a:ext cx="192360" cy="115417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zh-CN" sz="7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T</a:t>
                </a:r>
                <a:endParaRPr lang="zh-CN" alt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圆角矩形 151"/>
              <p:cNvSpPr/>
              <p:nvPr/>
            </p:nvSpPr>
            <p:spPr>
              <a:xfrm>
                <a:off x="5421034" y="834710"/>
                <a:ext cx="129600" cy="124416"/>
              </a:xfrm>
              <a:prstGeom prst="roundRect">
                <a:avLst/>
              </a:prstGeom>
              <a:gradFill flip="none" rotWithShape="1">
                <a:gsLst>
                  <a:gs pos="5000">
                    <a:schemeClr val="accent3">
                      <a:lumMod val="75000"/>
                    </a:schemeClr>
                  </a:gs>
                  <a:gs pos="50000">
                    <a:schemeClr val="bg1"/>
                  </a:gs>
                  <a:gs pos="100000">
                    <a:schemeClr val="accent3">
                      <a:lumMod val="75000"/>
                    </a:schemeClr>
                  </a:gs>
                </a:gsLst>
                <a:lin ang="16200000" scaled="1"/>
                <a:tileRect/>
              </a:gradFill>
              <a:ln w="3175">
                <a:solidFill>
                  <a:schemeClr val="bg2">
                    <a:lumMod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流程图: 准备 139"/>
              <p:cNvSpPr/>
              <p:nvPr/>
            </p:nvSpPr>
            <p:spPr>
              <a:xfrm>
                <a:off x="5408074" y="1063868"/>
                <a:ext cx="155520" cy="150936"/>
              </a:xfrm>
              <a:prstGeom prst="flowChartPreparation">
                <a:avLst/>
              </a:prstGeom>
              <a:pattFill prst="lgCheck">
                <a:fgClr>
                  <a:schemeClr val="accent3">
                    <a:lumMod val="75000"/>
                  </a:schemeClr>
                </a:fgClr>
                <a:bgClr>
                  <a:schemeClr val="bg1"/>
                </a:bgClr>
              </a:pattFill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矩形 140"/>
              <p:cNvSpPr/>
              <p:nvPr/>
            </p:nvSpPr>
            <p:spPr>
              <a:xfrm>
                <a:off x="5622749" y="1095016"/>
                <a:ext cx="621965" cy="115417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zh-CN" sz="75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utative signal</a:t>
                </a:r>
                <a:endParaRPr lang="zh-CN" altLang="en-US" sz="75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圆角矩形 138"/>
              <p:cNvSpPr/>
              <p:nvPr/>
            </p:nvSpPr>
            <p:spPr>
              <a:xfrm>
                <a:off x="5312394" y="763467"/>
                <a:ext cx="1041788" cy="529228"/>
              </a:xfrm>
              <a:prstGeom prst="round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75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2" name="组合 21"/>
            <p:cNvGrpSpPr/>
            <p:nvPr/>
          </p:nvGrpSpPr>
          <p:grpSpPr>
            <a:xfrm>
              <a:off x="2140132" y="933747"/>
              <a:ext cx="401024" cy="140560"/>
              <a:chOff x="-4059832" y="1266023"/>
              <a:chExt cx="598090" cy="209633"/>
            </a:xfrm>
          </p:grpSpPr>
          <p:sp>
            <p:nvSpPr>
              <p:cNvPr id="173" name="圆角矩形 172"/>
              <p:cNvSpPr/>
              <p:nvPr/>
            </p:nvSpPr>
            <p:spPr>
              <a:xfrm>
                <a:off x="-4055742" y="1334839"/>
                <a:ext cx="594000" cy="72000"/>
              </a:xfrm>
              <a:prstGeom prst="round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流程图: 准备 179"/>
              <p:cNvSpPr/>
              <p:nvPr/>
            </p:nvSpPr>
            <p:spPr>
              <a:xfrm>
                <a:off x="-4059832" y="1266023"/>
                <a:ext cx="230814" cy="209633"/>
              </a:xfrm>
              <a:prstGeom prst="flowChartPreparation">
                <a:avLst/>
              </a:prstGeom>
              <a:pattFill prst="lgCheck">
                <a:fgClr>
                  <a:schemeClr val="accent3">
                    <a:lumMod val="75000"/>
                  </a:schemeClr>
                </a:fgClr>
                <a:bgClr>
                  <a:schemeClr val="bg1"/>
                </a:bgClr>
              </a:pattFill>
              <a:ln w="6350" cmpd="sng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组合 3"/>
            <p:cNvGrpSpPr/>
            <p:nvPr/>
          </p:nvGrpSpPr>
          <p:grpSpPr>
            <a:xfrm>
              <a:off x="2142874" y="488388"/>
              <a:ext cx="2890012" cy="140560"/>
              <a:chOff x="1984661" y="258376"/>
              <a:chExt cx="3103337" cy="150936"/>
            </a:xfrm>
          </p:grpSpPr>
          <p:grpSp>
            <p:nvGrpSpPr>
              <p:cNvPr id="2" name="组合 1"/>
              <p:cNvGrpSpPr/>
              <p:nvPr/>
            </p:nvGrpSpPr>
            <p:grpSpPr>
              <a:xfrm>
                <a:off x="1984661" y="258376"/>
                <a:ext cx="3080945" cy="150936"/>
                <a:chOff x="1984661" y="258376"/>
                <a:chExt cx="3080945" cy="150936"/>
              </a:xfrm>
            </p:grpSpPr>
            <p:sp>
              <p:nvSpPr>
                <p:cNvPr id="111" name="圆角矩形 110"/>
                <p:cNvSpPr/>
                <p:nvPr/>
              </p:nvSpPr>
              <p:spPr>
                <a:xfrm>
                  <a:off x="1987606" y="307924"/>
                  <a:ext cx="3078000" cy="51840"/>
                </a:xfrm>
                <a:prstGeom prst="round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流程图: 准备 116"/>
                <p:cNvSpPr/>
                <p:nvPr/>
              </p:nvSpPr>
              <p:spPr>
                <a:xfrm>
                  <a:off x="1984661" y="258376"/>
                  <a:ext cx="166186" cy="150936"/>
                </a:xfrm>
                <a:prstGeom prst="flowChartPreparation">
                  <a:avLst/>
                </a:prstGeom>
                <a:pattFill prst="lgCheck">
                  <a:fgClr>
                    <a:schemeClr val="accent3">
                      <a:lumMod val="75000"/>
                    </a:schemeClr>
                  </a:fgClr>
                  <a:bgClr>
                    <a:schemeClr val="bg1"/>
                  </a:bgClr>
                </a:pattFill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9" name="圆角矩形 118"/>
                <p:cNvSpPr/>
                <p:nvPr/>
              </p:nvSpPr>
              <p:spPr>
                <a:xfrm>
                  <a:off x="2538698" y="271636"/>
                  <a:ext cx="2501280" cy="124416"/>
                </a:xfrm>
                <a:prstGeom prst="roundRect">
                  <a:avLst/>
                </a:prstGeom>
                <a:gradFill flip="none" rotWithShape="1">
                  <a:gsLst>
                    <a:gs pos="5000">
                      <a:schemeClr val="accent3">
                        <a:lumMod val="75000"/>
                      </a:schemeClr>
                    </a:gs>
                    <a:gs pos="50000">
                      <a:schemeClr val="bg1"/>
                    </a:gs>
                    <a:gs pos="100000">
                      <a:schemeClr val="accent3">
                        <a:lumMod val="75000"/>
                      </a:schemeClr>
                    </a:gs>
                  </a:gsLst>
                  <a:lin ang="16200000" scaled="1"/>
                  <a:tileRect/>
                </a:gradFill>
                <a:ln w="3175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8" name="圆角矩形 127"/>
              <p:cNvSpPr/>
              <p:nvPr/>
            </p:nvSpPr>
            <p:spPr>
              <a:xfrm>
                <a:off x="5069998" y="307653"/>
                <a:ext cx="18000" cy="51840"/>
              </a:xfrm>
              <a:prstGeom prst="roundRect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" name="组合 7"/>
            <p:cNvGrpSpPr/>
            <p:nvPr/>
          </p:nvGrpSpPr>
          <p:grpSpPr>
            <a:xfrm>
              <a:off x="2140132" y="711068"/>
              <a:ext cx="2920827" cy="140560"/>
              <a:chOff x="1981716" y="709761"/>
              <a:chExt cx="3136427" cy="150936"/>
            </a:xfrm>
          </p:grpSpPr>
          <p:grpSp>
            <p:nvGrpSpPr>
              <p:cNvPr id="129" name="组合 128"/>
              <p:cNvGrpSpPr/>
              <p:nvPr/>
            </p:nvGrpSpPr>
            <p:grpSpPr>
              <a:xfrm>
                <a:off x="1981716" y="709761"/>
                <a:ext cx="3080945" cy="150936"/>
                <a:chOff x="-4059832" y="905983"/>
                <a:chExt cx="4279090" cy="209633"/>
              </a:xfrm>
            </p:grpSpPr>
            <p:sp>
              <p:nvSpPr>
                <p:cNvPr id="130" name="圆角矩形 129"/>
                <p:cNvSpPr/>
                <p:nvPr/>
              </p:nvSpPr>
              <p:spPr>
                <a:xfrm>
                  <a:off x="-4055742" y="974800"/>
                  <a:ext cx="4275000" cy="72000"/>
                </a:xfrm>
                <a:prstGeom prst="roundRect">
                  <a:avLst/>
                </a:prstGeom>
                <a:solidFill>
                  <a:schemeClr val="accent3">
                    <a:lumMod val="75000"/>
                  </a:schemeClr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2" name="流程图: 准备 141"/>
                <p:cNvSpPr/>
                <p:nvPr/>
              </p:nvSpPr>
              <p:spPr>
                <a:xfrm>
                  <a:off x="-4059832" y="905983"/>
                  <a:ext cx="230814" cy="209633"/>
                </a:xfrm>
                <a:prstGeom prst="flowChartPreparation">
                  <a:avLst/>
                </a:prstGeom>
                <a:pattFill prst="lgCheck">
                  <a:fgClr>
                    <a:schemeClr val="accent3">
                      <a:lumMod val="75000"/>
                    </a:schemeClr>
                  </a:fgClr>
                  <a:bgClr>
                    <a:schemeClr val="bg1"/>
                  </a:bgClr>
                </a:pattFill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圆角矩形 142"/>
                <p:cNvSpPr/>
                <p:nvPr/>
              </p:nvSpPr>
              <p:spPr>
                <a:xfrm>
                  <a:off x="-3290336" y="924399"/>
                  <a:ext cx="3474000" cy="172800"/>
                </a:xfrm>
                <a:prstGeom prst="roundRect">
                  <a:avLst/>
                </a:prstGeom>
                <a:gradFill flip="none" rotWithShape="1">
                  <a:gsLst>
                    <a:gs pos="5000">
                      <a:schemeClr val="accent3">
                        <a:lumMod val="75000"/>
                      </a:schemeClr>
                    </a:gs>
                    <a:gs pos="50000">
                      <a:schemeClr val="bg1"/>
                    </a:gs>
                    <a:gs pos="100000">
                      <a:schemeClr val="accent3">
                        <a:lumMod val="75000"/>
                      </a:schemeClr>
                    </a:gs>
                  </a:gsLst>
                  <a:lin ang="16200000" scaled="1"/>
                  <a:tileRect/>
                </a:gradFill>
                <a:ln w="3175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53" name="圆角矩形 152"/>
              <p:cNvSpPr/>
              <p:nvPr/>
            </p:nvSpPr>
            <p:spPr>
              <a:xfrm>
                <a:off x="5066303" y="756818"/>
                <a:ext cx="51840" cy="51840"/>
              </a:xfrm>
              <a:prstGeom prst="round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7" name="TextBox 126"/>
            <p:cNvSpPr txBox="1"/>
            <p:nvPr/>
          </p:nvSpPr>
          <p:spPr>
            <a:xfrm>
              <a:off x="5418474" y="1168776"/>
              <a:ext cx="258890" cy="125100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zh-CN" sz="7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75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a</a:t>
              </a:r>
              <a:endParaRPr lang="zh-CN" altLang="en-US" sz="7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圆角矩形 154"/>
            <p:cNvSpPr/>
            <p:nvPr/>
          </p:nvSpPr>
          <p:spPr>
            <a:xfrm>
              <a:off x="5359906" y="1300324"/>
              <a:ext cx="366795" cy="48276"/>
            </a:xfrm>
            <a:prstGeom prst="roundRect">
              <a:avLst/>
            </a:prstGeom>
            <a:solidFill>
              <a:schemeClr val="accent3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75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" name="组合 5"/>
            <p:cNvGrpSpPr/>
            <p:nvPr/>
          </p:nvGrpSpPr>
          <p:grpSpPr>
            <a:xfrm>
              <a:off x="2658826" y="1168776"/>
              <a:ext cx="2377017" cy="115863"/>
              <a:chOff x="2538698" y="1430665"/>
              <a:chExt cx="2552475" cy="124416"/>
            </a:xfrm>
          </p:grpSpPr>
          <p:sp>
            <p:nvSpPr>
              <p:cNvPr id="157" name="圆角矩形 156"/>
              <p:cNvSpPr/>
              <p:nvPr/>
            </p:nvSpPr>
            <p:spPr>
              <a:xfrm>
                <a:off x="2906134" y="1466953"/>
                <a:ext cx="2160000" cy="51840"/>
              </a:xfrm>
              <a:prstGeom prst="round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圆角矩形 158"/>
              <p:cNvSpPr/>
              <p:nvPr/>
            </p:nvSpPr>
            <p:spPr>
              <a:xfrm>
                <a:off x="2538698" y="1430665"/>
                <a:ext cx="2501280" cy="124416"/>
              </a:xfrm>
              <a:prstGeom prst="roundRect">
                <a:avLst/>
              </a:prstGeom>
              <a:gradFill flip="none" rotWithShape="1">
                <a:gsLst>
                  <a:gs pos="5000">
                    <a:schemeClr val="accent3">
                      <a:lumMod val="75000"/>
                    </a:schemeClr>
                  </a:gs>
                  <a:gs pos="50000">
                    <a:schemeClr val="bg1"/>
                  </a:gs>
                  <a:gs pos="100000">
                    <a:schemeClr val="accent3">
                      <a:lumMod val="75000"/>
                    </a:schemeClr>
                  </a:gs>
                </a:gsLst>
                <a:lin ang="16200000" scaled="1"/>
                <a:tileRect/>
              </a:gradFill>
              <a:ln w="3175">
                <a:solidFill>
                  <a:schemeClr val="bg2">
                    <a:lumMod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圆角矩形 155"/>
              <p:cNvSpPr/>
              <p:nvPr/>
            </p:nvSpPr>
            <p:spPr>
              <a:xfrm>
                <a:off x="5073173" y="1466682"/>
                <a:ext cx="18000" cy="51840"/>
              </a:xfrm>
              <a:prstGeom prst="roundRect">
                <a:avLst/>
              </a:prstGeom>
              <a:solidFill>
                <a:srgbClr val="FF0000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组合 6"/>
            <p:cNvGrpSpPr/>
            <p:nvPr/>
          </p:nvGrpSpPr>
          <p:grpSpPr>
            <a:xfrm>
              <a:off x="2656085" y="1391454"/>
              <a:ext cx="2404717" cy="115863"/>
              <a:chOff x="2535754" y="1668080"/>
              <a:chExt cx="2582220" cy="124416"/>
            </a:xfrm>
          </p:grpSpPr>
          <p:sp>
            <p:nvSpPr>
              <p:cNvPr id="164" name="圆角矩形 163"/>
              <p:cNvSpPr/>
              <p:nvPr/>
            </p:nvSpPr>
            <p:spPr>
              <a:xfrm>
                <a:off x="2903976" y="1704369"/>
                <a:ext cx="2160000" cy="51840"/>
              </a:xfrm>
              <a:prstGeom prst="roundRect">
                <a:avLst/>
              </a:prstGeom>
              <a:solidFill>
                <a:schemeClr val="accent3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圆角矩形 165"/>
              <p:cNvSpPr/>
              <p:nvPr/>
            </p:nvSpPr>
            <p:spPr>
              <a:xfrm>
                <a:off x="2535754" y="1668080"/>
                <a:ext cx="2501279" cy="124416"/>
              </a:xfrm>
              <a:prstGeom prst="roundRect">
                <a:avLst/>
              </a:prstGeom>
              <a:gradFill flip="none" rotWithShape="1">
                <a:gsLst>
                  <a:gs pos="5000">
                    <a:schemeClr val="accent3">
                      <a:lumMod val="75000"/>
                    </a:schemeClr>
                  </a:gs>
                  <a:gs pos="50000">
                    <a:schemeClr val="bg1"/>
                  </a:gs>
                  <a:gs pos="100000">
                    <a:schemeClr val="accent3">
                      <a:lumMod val="75000"/>
                    </a:schemeClr>
                  </a:gs>
                </a:gsLst>
                <a:lin ang="16200000" scaled="1"/>
                <a:tileRect/>
              </a:gradFill>
              <a:ln w="3175">
                <a:solidFill>
                  <a:schemeClr val="bg2">
                    <a:lumMod val="2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圆角矩形 180"/>
              <p:cNvSpPr/>
              <p:nvPr/>
            </p:nvSpPr>
            <p:spPr>
              <a:xfrm>
                <a:off x="5066134" y="1705498"/>
                <a:ext cx="51840" cy="51840"/>
              </a:xfrm>
              <a:prstGeom prst="round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 lIns="0" tIns="0" rIns="0" bIns="0" rtlCol="0">
        <a:spAutoFit/>
      </a:bodyPr>
      <a:lstStyle>
        <a:defPPr>
          <a:defRPr sz="75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55</Words>
  <Application>WPS 演示</Application>
  <PresentationFormat>全屏显示(4:3)</PresentationFormat>
  <Paragraphs>713</Paragraphs>
  <Slides>11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2</vt:i4>
      </vt:variant>
      <vt:variant>
        <vt:lpstr>嵌入 OLE 服务器</vt:lpstr>
      </vt:variant>
      <vt:variant>
        <vt:i4>10</vt:i4>
      </vt:variant>
      <vt:variant>
        <vt:lpstr>幻灯片标题</vt:lpstr>
      </vt:variant>
      <vt:variant>
        <vt:i4>11</vt:i4>
      </vt:variant>
    </vt:vector>
  </HeadingPairs>
  <TitlesOfParts>
    <vt:vector size="35" baseType="lpstr">
      <vt:lpstr>Arial</vt:lpstr>
      <vt:lpstr>宋体</vt:lpstr>
      <vt:lpstr>Wingdings</vt:lpstr>
      <vt:lpstr>Times New Roman</vt:lpstr>
      <vt:lpstr>Tahoma</vt:lpstr>
      <vt:lpstr>Arial</vt:lpstr>
      <vt:lpstr>Courier New</vt:lpstr>
      <vt:lpstr>Courier New</vt:lpstr>
      <vt:lpstr>Times New Roman</vt:lpstr>
      <vt:lpstr>微软雅黑</vt:lpstr>
      <vt:lpstr>Arial Unicode MS</vt:lpstr>
      <vt:lpstr>Calibri</vt:lpstr>
      <vt:lpstr>Office 主题</vt:lpstr>
      <vt:lpstr>1_Office 主题</vt:lpstr>
      <vt:lpstr>Prism8.Document</vt:lpstr>
      <vt:lpstr>Prism8.Document</vt:lpstr>
      <vt:lpstr>Prism8.Document</vt:lpstr>
      <vt:lpstr>Prism8.Document</vt:lpstr>
      <vt:lpstr>KingDrawXObject</vt:lpstr>
      <vt:lpstr>KingDrawXObject</vt:lpstr>
      <vt:lpstr>KingDrawXObject</vt:lpstr>
      <vt:lpstr>KingDrawXObject</vt:lpstr>
      <vt:lpstr>KingDrawXObject</vt:lpstr>
      <vt:lpstr>KingDrawXOb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j</dc:creator>
  <cp:lastModifiedBy>袁文雅</cp:lastModifiedBy>
  <cp:revision>1189</cp:revision>
  <dcterms:created xsi:type="dcterms:W3CDTF">2023-06-04T13:14:00Z</dcterms:created>
  <dcterms:modified xsi:type="dcterms:W3CDTF">2025-09-24T09:3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7BA9E6362E547D398D15F387001B5D0_13</vt:lpwstr>
  </property>
  <property fmtid="{D5CDD505-2E9C-101B-9397-08002B2CF9AE}" pid="3" name="KSOProductBuildVer">
    <vt:lpwstr>2052-12.1.0.21915</vt:lpwstr>
  </property>
</Properties>
</file>